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67" r:id="rId3"/>
    <p:sldId id="259" r:id="rId4"/>
    <p:sldId id="260" r:id="rId5"/>
    <p:sldId id="261" r:id="rId6"/>
    <p:sldId id="262" r:id="rId7"/>
    <p:sldId id="263" r:id="rId8"/>
    <p:sldId id="264" r:id="rId9"/>
    <p:sldId id="258" r:id="rId10"/>
    <p:sldId id="265" r:id="rId11"/>
  </p:sldIdLst>
  <p:sldSz cx="6858000" cy="9906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5320" autoAdjust="0"/>
  </p:normalViewPr>
  <p:slideViewPr>
    <p:cSldViewPr snapToGrid="0">
      <p:cViewPr varScale="1">
        <p:scale>
          <a:sx n="39" d="100"/>
          <a:sy n="39" d="100"/>
        </p:scale>
        <p:origin x="2045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F3D53-3CA0-4BFE-9FB5-AF59B3086AD6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03B03-C253-42A3-83E3-2DA0B8C0A7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0992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F3D53-3CA0-4BFE-9FB5-AF59B3086AD6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03B03-C253-42A3-83E3-2DA0B8C0A7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5298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F3D53-3CA0-4BFE-9FB5-AF59B3086AD6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03B03-C253-42A3-83E3-2DA0B8C0A7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5581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F3D53-3CA0-4BFE-9FB5-AF59B3086AD6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03B03-C253-42A3-83E3-2DA0B8C0A7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2144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F3D53-3CA0-4BFE-9FB5-AF59B3086AD6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03B03-C253-42A3-83E3-2DA0B8C0A7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251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F3D53-3CA0-4BFE-9FB5-AF59B3086AD6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03B03-C253-42A3-83E3-2DA0B8C0A7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2768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F3D53-3CA0-4BFE-9FB5-AF59B3086AD6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03B03-C253-42A3-83E3-2DA0B8C0A7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53444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F3D53-3CA0-4BFE-9FB5-AF59B3086AD6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03B03-C253-42A3-83E3-2DA0B8C0A7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12402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F3D53-3CA0-4BFE-9FB5-AF59B3086AD6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03B03-C253-42A3-83E3-2DA0B8C0A7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7668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F3D53-3CA0-4BFE-9FB5-AF59B3086AD6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03B03-C253-42A3-83E3-2DA0B8C0A7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43049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F3D53-3CA0-4BFE-9FB5-AF59B3086AD6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03B03-C253-42A3-83E3-2DA0B8C0A7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34859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AF3D53-3CA0-4BFE-9FB5-AF59B3086AD6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703B03-C253-42A3-83E3-2DA0B8C0A7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670478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jpg"/><Relationship Id="rId2" Type="http://schemas.openxmlformats.org/officeDocument/2006/relationships/image" Target="../media/image76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g"/><Relationship Id="rId13" Type="http://schemas.openxmlformats.org/officeDocument/2006/relationships/image" Target="../media/image14.jpg"/><Relationship Id="rId18" Type="http://schemas.openxmlformats.org/officeDocument/2006/relationships/image" Target="../media/image19.jpg"/><Relationship Id="rId3" Type="http://schemas.openxmlformats.org/officeDocument/2006/relationships/image" Target="../media/image4.jpeg"/><Relationship Id="rId7" Type="http://schemas.openxmlformats.org/officeDocument/2006/relationships/image" Target="../media/image8.png"/><Relationship Id="rId12" Type="http://schemas.openxmlformats.org/officeDocument/2006/relationships/image" Target="../media/image13.jpg"/><Relationship Id="rId17" Type="http://schemas.openxmlformats.org/officeDocument/2006/relationships/image" Target="../media/image18.jpg"/><Relationship Id="rId2" Type="http://schemas.openxmlformats.org/officeDocument/2006/relationships/image" Target="../media/image3.png"/><Relationship Id="rId16" Type="http://schemas.openxmlformats.org/officeDocument/2006/relationships/image" Target="../media/image17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jpeg"/><Relationship Id="rId11" Type="http://schemas.openxmlformats.org/officeDocument/2006/relationships/image" Target="../media/image12.png"/><Relationship Id="rId5" Type="http://schemas.openxmlformats.org/officeDocument/2006/relationships/image" Target="../media/image6.jpeg"/><Relationship Id="rId15" Type="http://schemas.openxmlformats.org/officeDocument/2006/relationships/image" Target="../media/image16.jpeg"/><Relationship Id="rId10" Type="http://schemas.openxmlformats.org/officeDocument/2006/relationships/image" Target="../media/image11.jpeg"/><Relationship Id="rId4" Type="http://schemas.openxmlformats.org/officeDocument/2006/relationships/image" Target="../media/image5.jpeg"/><Relationship Id="rId9" Type="http://schemas.openxmlformats.org/officeDocument/2006/relationships/image" Target="../media/image10.jpeg"/><Relationship Id="rId14" Type="http://schemas.openxmlformats.org/officeDocument/2006/relationships/image" Target="../media/image15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openxmlformats.org/officeDocument/2006/relationships/image" Target="../media/image21.jpeg"/><Relationship Id="rId7" Type="http://schemas.openxmlformats.org/officeDocument/2006/relationships/image" Target="../media/image25.jpg"/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jpg"/><Relationship Id="rId11" Type="http://schemas.openxmlformats.org/officeDocument/2006/relationships/image" Target="../media/image29.jpeg"/><Relationship Id="rId5" Type="http://schemas.openxmlformats.org/officeDocument/2006/relationships/image" Target="../media/image23.jpg"/><Relationship Id="rId10" Type="http://schemas.openxmlformats.org/officeDocument/2006/relationships/image" Target="../media/image28.jpg"/><Relationship Id="rId4" Type="http://schemas.openxmlformats.org/officeDocument/2006/relationships/image" Target="../media/image22.tiff"/><Relationship Id="rId9" Type="http://schemas.openxmlformats.org/officeDocument/2006/relationships/image" Target="../media/image27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jpg"/><Relationship Id="rId3" Type="http://schemas.openxmlformats.org/officeDocument/2006/relationships/image" Target="../media/image31.jpg"/><Relationship Id="rId7" Type="http://schemas.openxmlformats.org/officeDocument/2006/relationships/image" Target="../media/image35.jpg"/><Relationship Id="rId2" Type="http://schemas.openxmlformats.org/officeDocument/2006/relationships/image" Target="../media/image30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4.png"/><Relationship Id="rId5" Type="http://schemas.openxmlformats.org/officeDocument/2006/relationships/image" Target="../media/image33.jpg"/><Relationship Id="rId4" Type="http://schemas.openxmlformats.org/officeDocument/2006/relationships/image" Target="../media/image32.jpeg"/><Relationship Id="rId9" Type="http://schemas.openxmlformats.org/officeDocument/2006/relationships/image" Target="../media/image37.jp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png"/><Relationship Id="rId13" Type="http://schemas.openxmlformats.org/officeDocument/2006/relationships/image" Target="../media/image47.jpg"/><Relationship Id="rId3" Type="http://schemas.openxmlformats.org/officeDocument/2006/relationships/image" Target="../media/image36.jpg"/><Relationship Id="rId7" Type="http://schemas.openxmlformats.org/officeDocument/2006/relationships/image" Target="../media/image41.jpg"/><Relationship Id="rId12" Type="http://schemas.openxmlformats.org/officeDocument/2006/relationships/image" Target="../media/image46.jpg"/><Relationship Id="rId2" Type="http://schemas.openxmlformats.org/officeDocument/2006/relationships/image" Target="../media/image38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jpg"/><Relationship Id="rId11" Type="http://schemas.openxmlformats.org/officeDocument/2006/relationships/image" Target="../media/image45.jpg"/><Relationship Id="rId5" Type="http://schemas.openxmlformats.org/officeDocument/2006/relationships/image" Target="../media/image39.png"/><Relationship Id="rId10" Type="http://schemas.openxmlformats.org/officeDocument/2006/relationships/image" Target="../media/image44.jpg"/><Relationship Id="rId4" Type="http://schemas.openxmlformats.org/officeDocument/2006/relationships/image" Target="../media/image35.jpg"/><Relationship Id="rId9" Type="http://schemas.openxmlformats.org/officeDocument/2006/relationships/image" Target="../media/image43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3.jpg"/><Relationship Id="rId3" Type="http://schemas.openxmlformats.org/officeDocument/2006/relationships/image" Target="../media/image49.png"/><Relationship Id="rId7" Type="http://schemas.microsoft.com/office/2007/relationships/hdphoto" Target="../media/hdphoto1.wdp"/><Relationship Id="rId12" Type="http://schemas.openxmlformats.org/officeDocument/2006/relationships/image" Target="../media/image56.jpg"/><Relationship Id="rId2" Type="http://schemas.openxmlformats.org/officeDocument/2006/relationships/image" Target="../media/image48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2.png"/><Relationship Id="rId11" Type="http://schemas.openxmlformats.org/officeDocument/2006/relationships/image" Target="../media/image55.png"/><Relationship Id="rId5" Type="http://schemas.openxmlformats.org/officeDocument/2006/relationships/image" Target="../media/image51.jpeg"/><Relationship Id="rId10" Type="http://schemas.microsoft.com/office/2007/relationships/hdphoto" Target="../media/hdphoto2.wdp"/><Relationship Id="rId4" Type="http://schemas.openxmlformats.org/officeDocument/2006/relationships/image" Target="../media/image50.jpeg"/><Relationship Id="rId9" Type="http://schemas.openxmlformats.org/officeDocument/2006/relationships/image" Target="../media/image54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3.jpg"/><Relationship Id="rId3" Type="http://schemas.openxmlformats.org/officeDocument/2006/relationships/image" Target="../media/image58.png"/><Relationship Id="rId7" Type="http://schemas.openxmlformats.org/officeDocument/2006/relationships/image" Target="../media/image62.jpg"/><Relationship Id="rId2" Type="http://schemas.openxmlformats.org/officeDocument/2006/relationships/image" Target="../media/image57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1.jpg"/><Relationship Id="rId5" Type="http://schemas.openxmlformats.org/officeDocument/2006/relationships/image" Target="../media/image60.jpeg"/><Relationship Id="rId4" Type="http://schemas.openxmlformats.org/officeDocument/2006/relationships/image" Target="../media/image59.jpe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70.jpg"/><Relationship Id="rId3" Type="http://schemas.openxmlformats.org/officeDocument/2006/relationships/image" Target="../media/image65.jpg"/><Relationship Id="rId7" Type="http://schemas.openxmlformats.org/officeDocument/2006/relationships/image" Target="../media/image69.jpg"/><Relationship Id="rId2" Type="http://schemas.openxmlformats.org/officeDocument/2006/relationships/image" Target="../media/image64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8.jpeg"/><Relationship Id="rId5" Type="http://schemas.openxmlformats.org/officeDocument/2006/relationships/image" Target="../media/image67.png"/><Relationship Id="rId10" Type="http://schemas.openxmlformats.org/officeDocument/2006/relationships/image" Target="../media/image72.jpg"/><Relationship Id="rId4" Type="http://schemas.openxmlformats.org/officeDocument/2006/relationships/image" Target="../media/image66.jpg"/><Relationship Id="rId9" Type="http://schemas.openxmlformats.org/officeDocument/2006/relationships/image" Target="../media/image71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jpeg"/><Relationship Id="rId2" Type="http://schemas.openxmlformats.org/officeDocument/2006/relationships/image" Target="../media/image7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jpg"/><Relationship Id="rId5" Type="http://schemas.microsoft.com/office/2007/relationships/hdphoto" Target="../media/hdphoto3.wdp"/><Relationship Id="rId4" Type="http://schemas.openxmlformats.org/officeDocument/2006/relationships/image" Target="../media/image7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179079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684392" y="248171"/>
            <a:ext cx="418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260000" flipV="1">
            <a:off x="2264395" y="176931"/>
            <a:ext cx="323165" cy="65282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260000" flipV="1">
            <a:off x="3198534" y="176931"/>
            <a:ext cx="323165" cy="65282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PLC/PRF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260000" flipV="1">
            <a:off x="2843864" y="409750"/>
            <a:ext cx="323165" cy="41200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Huh7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260000" flipV="1">
            <a:off x="2570200" y="176931"/>
            <a:ext cx="323165" cy="65282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Hep3B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762324" y="894563"/>
            <a:ext cx="62429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UBE2M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>
            <a:spLocks/>
          </p:cNvSpPr>
          <p:nvPr/>
        </p:nvSpPr>
        <p:spPr>
          <a:xfrm>
            <a:off x="3774918" y="1237674"/>
            <a:ext cx="62429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567326" y="804763"/>
            <a:ext cx="66352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570501" y="1287929"/>
            <a:ext cx="66352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그림 13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84" t="49933" r="50241" b="46582"/>
          <a:stretch/>
        </p:blipFill>
        <p:spPr>
          <a:xfrm>
            <a:off x="2141122" y="1182907"/>
            <a:ext cx="162000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그림 14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23" t="56731" r="51850" b="38014"/>
          <a:stretch/>
        </p:blipFill>
        <p:spPr>
          <a:xfrm>
            <a:off x="2141122" y="836068"/>
            <a:ext cx="162000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TextBox 15"/>
          <p:cNvSpPr txBox="1"/>
          <p:nvPr/>
        </p:nvSpPr>
        <p:spPr>
          <a:xfrm rot="1260000" flipV="1">
            <a:off x="3501607" y="57803"/>
            <a:ext cx="461665" cy="75037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Normal Hepatocyte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그림 16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50" t="749" r="46484" b="46068"/>
          <a:stretch/>
        </p:blipFill>
        <p:spPr>
          <a:xfrm>
            <a:off x="276146" y="2003439"/>
            <a:ext cx="2199190" cy="43950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그림 17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47" t="53451" r="25072" b="-36"/>
          <a:stretch/>
        </p:blipFill>
        <p:spPr>
          <a:xfrm>
            <a:off x="2951122" y="2924408"/>
            <a:ext cx="3475502" cy="255313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직사각형 18"/>
          <p:cNvSpPr/>
          <p:nvPr/>
        </p:nvSpPr>
        <p:spPr>
          <a:xfrm>
            <a:off x="639850" y="6029382"/>
            <a:ext cx="1732960" cy="3691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" name="직사각형 19"/>
          <p:cNvSpPr/>
          <p:nvPr/>
        </p:nvSpPr>
        <p:spPr>
          <a:xfrm>
            <a:off x="3520138" y="2997933"/>
            <a:ext cx="1732960" cy="5290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938138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56" t="85940" r="79124" b="11050"/>
          <a:stretch/>
        </p:blipFill>
        <p:spPr>
          <a:xfrm>
            <a:off x="2136523" y="2195533"/>
            <a:ext cx="648000" cy="2855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그림 3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52" t="57234" r="78360" b="37538"/>
          <a:stretch/>
        </p:blipFill>
        <p:spPr>
          <a:xfrm>
            <a:off x="2136523" y="1840465"/>
            <a:ext cx="648000" cy="30376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5" name="직선 연결선 4"/>
          <p:cNvCxnSpPr/>
          <p:nvPr/>
        </p:nvCxnSpPr>
        <p:spPr>
          <a:xfrm>
            <a:off x="2191250" y="1401181"/>
            <a:ext cx="5479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1442483" y="1612997"/>
            <a:ext cx="7405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shUBE2M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442483" y="1383592"/>
            <a:ext cx="7405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shCTL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055217" y="1165697"/>
            <a:ext cx="8175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234611" y="1402589"/>
            <a:ext cx="1658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234611" y="1587968"/>
            <a:ext cx="1658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534047" y="1390077"/>
            <a:ext cx="1658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534047" y="1587968"/>
            <a:ext cx="1658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762979" y="2178776"/>
            <a:ext cx="60891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733553" y="1882055"/>
            <a:ext cx="5860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UBE2M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275444" y="703376"/>
            <a:ext cx="418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510646" y="2318008"/>
            <a:ext cx="71970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35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510646" y="1928886"/>
            <a:ext cx="71970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2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그림 32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4" t="84494" r="62883" b="9406"/>
          <a:stretch/>
        </p:blipFill>
        <p:spPr>
          <a:xfrm>
            <a:off x="1636510" y="4186782"/>
            <a:ext cx="1527858" cy="57873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그림 33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77" t="54359" r="62637" b="35702"/>
          <a:stretch/>
        </p:blipFill>
        <p:spPr>
          <a:xfrm>
            <a:off x="1713053" y="3298785"/>
            <a:ext cx="1539093" cy="57755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5" name="직사각형 34"/>
          <p:cNvSpPr/>
          <p:nvPr/>
        </p:nvSpPr>
        <p:spPr>
          <a:xfrm>
            <a:off x="2460523" y="3289628"/>
            <a:ext cx="703845" cy="5377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6" name="직사각형 35"/>
          <p:cNvSpPr/>
          <p:nvPr/>
        </p:nvSpPr>
        <p:spPr>
          <a:xfrm>
            <a:off x="2381630" y="4186782"/>
            <a:ext cx="703845" cy="5377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2" name="TextBox 21"/>
          <p:cNvSpPr txBox="1"/>
          <p:nvPr/>
        </p:nvSpPr>
        <p:spPr>
          <a:xfrm>
            <a:off x="0" y="179079"/>
            <a:ext cx="21739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72111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179079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그룹 2">
            <a:extLst>
              <a:ext uri="{FF2B5EF4-FFF2-40B4-BE49-F238E27FC236}">
                <a16:creationId xmlns:a16="http://schemas.microsoft.com/office/drawing/2014/main" id="{CC0228CC-3F96-437E-9B32-E8B1B45F7E1D}"/>
              </a:ext>
            </a:extLst>
          </p:cNvPr>
          <p:cNvGrpSpPr/>
          <p:nvPr/>
        </p:nvGrpSpPr>
        <p:grpSpPr>
          <a:xfrm>
            <a:off x="0" y="875241"/>
            <a:ext cx="4120409" cy="2200119"/>
            <a:chOff x="-313890" y="69695"/>
            <a:chExt cx="4963780" cy="1987069"/>
          </a:xfrm>
        </p:grpSpPr>
        <p:grpSp>
          <p:nvGrpSpPr>
            <p:cNvPr id="4" name="그룹 3">
              <a:extLst>
                <a:ext uri="{FF2B5EF4-FFF2-40B4-BE49-F238E27FC236}">
                  <a16:creationId xmlns:a16="http://schemas.microsoft.com/office/drawing/2014/main" id="{92B18E93-6F2E-487D-B6E6-95253609F81E}"/>
                </a:ext>
              </a:extLst>
            </p:cNvPr>
            <p:cNvGrpSpPr/>
            <p:nvPr/>
          </p:nvGrpSpPr>
          <p:grpSpPr>
            <a:xfrm>
              <a:off x="3079770" y="981696"/>
              <a:ext cx="1570120" cy="472326"/>
              <a:chOff x="3079770" y="981696"/>
              <a:chExt cx="1570120" cy="472326"/>
            </a:xfrm>
          </p:grpSpPr>
          <p:sp>
            <p:nvSpPr>
              <p:cNvPr id="56" name="TextBox 55"/>
              <p:cNvSpPr txBox="1"/>
              <p:nvPr/>
            </p:nvSpPr>
            <p:spPr>
              <a:xfrm>
                <a:off x="3079770" y="1225949"/>
                <a:ext cx="1570120" cy="2280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leaved caspase-3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3079771" y="981696"/>
                <a:ext cx="1513950" cy="2223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 Cleaved 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ARP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" name="그룹 4">
              <a:extLst>
                <a:ext uri="{FF2B5EF4-FFF2-40B4-BE49-F238E27FC236}">
                  <a16:creationId xmlns:a16="http://schemas.microsoft.com/office/drawing/2014/main" id="{46B3C06D-3B96-4DAC-835B-C65A27D9ED85}"/>
                </a:ext>
              </a:extLst>
            </p:cNvPr>
            <p:cNvGrpSpPr/>
            <p:nvPr/>
          </p:nvGrpSpPr>
          <p:grpSpPr>
            <a:xfrm>
              <a:off x="-313890" y="69695"/>
              <a:ext cx="4578381" cy="1987069"/>
              <a:chOff x="-313890" y="69695"/>
              <a:chExt cx="4578381" cy="1987069"/>
            </a:xfrm>
          </p:grpSpPr>
          <p:sp>
            <p:nvSpPr>
              <p:cNvPr id="6" name="TextBox 5"/>
              <p:cNvSpPr txBox="1"/>
              <p:nvPr/>
            </p:nvSpPr>
            <p:spPr>
              <a:xfrm>
                <a:off x="73519" y="69695"/>
                <a:ext cx="28601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-61367" y="416645"/>
                <a:ext cx="732552" cy="2223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CTL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-313890" y="625944"/>
                <a:ext cx="985073" cy="2223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iUBE2M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3079773" y="1499717"/>
                <a:ext cx="76572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UBE2M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3079773" y="1782009"/>
                <a:ext cx="73093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85147" y="1489692"/>
                <a:ext cx="663724" cy="1818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0 </a:t>
                </a:r>
                <a:r>
                  <a:rPr lang="en-US" altLang="ko-KR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85147" y="1874896"/>
                <a:ext cx="663724" cy="1818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5 </a:t>
                </a:r>
                <a:r>
                  <a:rPr lang="en-US" altLang="ko-KR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3" name="그림 12"/>
              <p:cNvPicPr preferRelativeResize="0">
                <a:picLocks/>
              </p:cNvPicPr>
              <p:nvPr/>
            </p:nvPicPr>
            <p:blipFill rotWithShape="1">
              <a:blip r:embed="rId2"/>
              <a:srcRect l="2590" t="1" r="3672" b="17220"/>
              <a:stretch/>
            </p:blipFill>
            <p:spPr>
              <a:xfrm>
                <a:off x="2553792" y="1472967"/>
                <a:ext cx="589091" cy="26181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14" name="직선 연결선 13"/>
              <p:cNvCxnSpPr/>
              <p:nvPr/>
            </p:nvCxnSpPr>
            <p:spPr>
              <a:xfrm>
                <a:off x="2546704" y="451697"/>
                <a:ext cx="52624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TextBox 14"/>
              <p:cNvSpPr txBox="1"/>
              <p:nvPr/>
            </p:nvSpPr>
            <p:spPr>
              <a:xfrm>
                <a:off x="2636456" y="417309"/>
                <a:ext cx="67816" cy="2098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2939721" y="417309"/>
                <a:ext cx="67816" cy="2098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2636456" y="570738"/>
                <a:ext cx="67816" cy="2098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2939721" y="570738"/>
                <a:ext cx="67816" cy="2098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2370106" y="230304"/>
                <a:ext cx="1039810" cy="2223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LC/PRF5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0" name="직선 연결선 19"/>
              <p:cNvCxnSpPr/>
              <p:nvPr/>
            </p:nvCxnSpPr>
            <p:spPr>
              <a:xfrm>
                <a:off x="1935912" y="451697"/>
                <a:ext cx="52624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TextBox 20"/>
              <p:cNvSpPr txBox="1"/>
              <p:nvPr/>
            </p:nvSpPr>
            <p:spPr>
              <a:xfrm>
                <a:off x="2042129" y="416644"/>
                <a:ext cx="67816" cy="2098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2345393" y="416644"/>
                <a:ext cx="67816" cy="2098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2042129" y="570073"/>
                <a:ext cx="67816" cy="2098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2345393" y="570073"/>
                <a:ext cx="67816" cy="2098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1911928" y="221701"/>
                <a:ext cx="644743" cy="2223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uh7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6" name="그림 25"/>
              <p:cNvPicPr preferRelativeResize="0">
                <a:picLocks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581" t="91316" r="49679" b="5464"/>
              <a:stretch/>
            </p:blipFill>
            <p:spPr>
              <a:xfrm>
                <a:off x="2553792" y="1773629"/>
                <a:ext cx="589091" cy="26181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7" name="그림 26"/>
              <p:cNvPicPr preferRelativeResize="0">
                <a:picLocks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844" t="91344" r="37060" b="5396"/>
              <a:stretch/>
            </p:blipFill>
            <p:spPr>
              <a:xfrm>
                <a:off x="1926665" y="1773629"/>
                <a:ext cx="589091" cy="26181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8" name="TextBox 27"/>
              <p:cNvSpPr txBox="1"/>
              <p:nvPr/>
            </p:nvSpPr>
            <p:spPr>
              <a:xfrm>
                <a:off x="3079771" y="778245"/>
                <a:ext cx="1184720" cy="2303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 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ro-PARP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9" name="그림 28"/>
              <p:cNvPicPr preferRelativeResize="0">
                <a:picLocks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921" t="21387" r="47457" b="69417"/>
              <a:stretch/>
            </p:blipFill>
            <p:spPr>
              <a:xfrm>
                <a:off x="2553792" y="797189"/>
                <a:ext cx="589091" cy="32727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30" name="TextBox 29"/>
              <p:cNvSpPr txBox="1"/>
              <p:nvPr/>
            </p:nvSpPr>
            <p:spPr>
              <a:xfrm>
                <a:off x="85147" y="1102353"/>
                <a:ext cx="663724" cy="1818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0 </a:t>
                </a:r>
                <a:r>
                  <a:rPr lang="en-US" altLang="ko-KR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1" name="그림 30"/>
              <p:cNvPicPr preferRelativeResize="0">
                <a:picLocks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030" t="17544" r="32874" b="77113"/>
              <a:stretch/>
            </p:blipFill>
            <p:spPr>
              <a:xfrm>
                <a:off x="1926665" y="797189"/>
                <a:ext cx="589091" cy="32727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32" name="TextBox 31"/>
              <p:cNvSpPr txBox="1"/>
              <p:nvPr/>
            </p:nvSpPr>
            <p:spPr>
              <a:xfrm>
                <a:off x="85147" y="835473"/>
                <a:ext cx="663724" cy="1818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00 </a:t>
                </a:r>
                <a:r>
                  <a:rPr lang="en-US" altLang="ko-KR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3" name="그림 32"/>
              <p:cNvPicPr preferRelativeResize="0">
                <a:picLocks/>
              </p:cNvPicPr>
              <p:nvPr/>
            </p:nvPicPr>
            <p:blipFill rotWithShape="1">
              <a:blip r:embed="rId7"/>
              <a:srcRect t="10452" b="8095"/>
              <a:stretch/>
            </p:blipFill>
            <p:spPr>
              <a:xfrm>
                <a:off x="1926665" y="1172304"/>
                <a:ext cx="589091" cy="26181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4" name="그림 33"/>
              <p:cNvPicPr preferRelativeResize="0">
                <a:picLocks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666" t="47298" r="63519" b="47708"/>
              <a:stretch/>
            </p:blipFill>
            <p:spPr>
              <a:xfrm>
                <a:off x="2553792" y="1172304"/>
                <a:ext cx="589091" cy="26181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5" name="그림 34"/>
              <p:cNvPicPr preferRelativeResize="0">
                <a:picLocks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5935" t="47779" r="31288" b="48622"/>
              <a:stretch/>
            </p:blipFill>
            <p:spPr>
              <a:xfrm>
                <a:off x="662308" y="1468063"/>
                <a:ext cx="589091" cy="26181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6" name="그림 35"/>
              <p:cNvPicPr preferRelativeResize="0">
                <a:picLocks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0694" t="17717" r="26370" b="79136"/>
              <a:stretch/>
            </p:blipFill>
            <p:spPr>
              <a:xfrm>
                <a:off x="662308" y="1773629"/>
                <a:ext cx="589091" cy="26181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7" name="그림 36"/>
              <p:cNvPicPr preferRelativeResize="0">
                <a:picLocks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662308" y="1162499"/>
                <a:ext cx="589091" cy="26181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38" name="직선 연결선 37"/>
              <p:cNvCxnSpPr/>
              <p:nvPr/>
            </p:nvCxnSpPr>
            <p:spPr>
              <a:xfrm>
                <a:off x="669600" y="434154"/>
                <a:ext cx="52624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TextBox 38"/>
              <p:cNvSpPr txBox="1"/>
              <p:nvPr/>
            </p:nvSpPr>
            <p:spPr>
              <a:xfrm>
                <a:off x="775818" y="399101"/>
                <a:ext cx="67816" cy="2098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1079081" y="399101"/>
                <a:ext cx="67816" cy="2098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775818" y="552530"/>
                <a:ext cx="67816" cy="2098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1079081" y="552530"/>
                <a:ext cx="67816" cy="2098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561688" y="212761"/>
                <a:ext cx="710874" cy="2223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epG2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4" name="직선 연결선 43"/>
              <p:cNvCxnSpPr/>
              <p:nvPr/>
            </p:nvCxnSpPr>
            <p:spPr>
              <a:xfrm>
                <a:off x="1291572" y="439149"/>
                <a:ext cx="52624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TextBox 44"/>
              <p:cNvSpPr txBox="1"/>
              <p:nvPr/>
            </p:nvSpPr>
            <p:spPr>
              <a:xfrm>
                <a:off x="1397789" y="404096"/>
                <a:ext cx="67816" cy="2098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1701053" y="404096"/>
                <a:ext cx="67816" cy="2098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1397789" y="557525"/>
                <a:ext cx="67816" cy="2098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1701053" y="557525"/>
                <a:ext cx="67816" cy="2098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1190717" y="217756"/>
                <a:ext cx="753139" cy="2223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ep3B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50" name="그림 49"/>
              <p:cNvPicPr preferRelativeResize="0">
                <a:picLocks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337" t="12064" r="39765" b="81448"/>
              <a:stretch/>
            </p:blipFill>
            <p:spPr>
              <a:xfrm>
                <a:off x="1294393" y="791480"/>
                <a:ext cx="589091" cy="32727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1" name="그림 50"/>
              <p:cNvPicPr preferRelativeResize="0">
                <a:picLocks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4622" t="63173" r="41496" b="32733"/>
              <a:stretch/>
            </p:blipFill>
            <p:spPr>
              <a:xfrm>
                <a:off x="1294393" y="1468063"/>
                <a:ext cx="589091" cy="26181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2" name="그림 51"/>
              <p:cNvPicPr preferRelativeResize="0">
                <a:picLocks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1893" t="70031" r="24385" b="27157"/>
              <a:stretch/>
            </p:blipFill>
            <p:spPr>
              <a:xfrm>
                <a:off x="1294393" y="1773629"/>
                <a:ext cx="589091" cy="26181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3" name="그림 52"/>
              <p:cNvPicPr preferRelativeResize="0">
                <a:picLocks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021" t="52408" r="45977" b="41960"/>
              <a:stretch/>
            </p:blipFill>
            <p:spPr>
              <a:xfrm>
                <a:off x="1294393" y="1162499"/>
                <a:ext cx="589091" cy="26181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4" name="그림 53"/>
              <p:cNvPicPr preferRelativeResize="0">
                <a:picLocks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1508" t="50078" r="26738" b="45872"/>
              <a:stretch/>
            </p:blipFill>
            <p:spPr>
              <a:xfrm>
                <a:off x="1926478" y="1474409"/>
                <a:ext cx="589091" cy="26181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5" name="그림 54"/>
              <p:cNvPicPr preferRelativeResize="0">
                <a:picLocks/>
              </p:cNvPicPr>
              <p:nvPr/>
            </p:nvPicPr>
            <p:blipFill rotWithShape="1"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3638" t="20314" r="32681" b="74368"/>
              <a:stretch/>
            </p:blipFill>
            <p:spPr>
              <a:xfrm>
                <a:off x="662308" y="791480"/>
                <a:ext cx="589091" cy="32727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</p:grpSp>
      <p:sp>
        <p:nvSpPr>
          <p:cNvPr id="58" name="TextBox 57">
            <a:extLst>
              <a:ext uri="{FF2B5EF4-FFF2-40B4-BE49-F238E27FC236}">
                <a16:creationId xmlns:a16="http://schemas.microsoft.com/office/drawing/2014/main" id="{A9569372-953B-40D3-8083-7C15B8B2CEF3}"/>
              </a:ext>
            </a:extLst>
          </p:cNvPr>
          <p:cNvSpPr txBox="1"/>
          <p:nvPr/>
        </p:nvSpPr>
        <p:spPr>
          <a:xfrm>
            <a:off x="109395" y="806932"/>
            <a:ext cx="418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0" name="그림 79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80" t="91316" r="23761" b="4639"/>
          <a:stretch/>
        </p:blipFill>
        <p:spPr>
          <a:xfrm>
            <a:off x="5149230" y="6818297"/>
            <a:ext cx="1483858" cy="364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1" name="그림 80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36" t="91344" r="22615" b="3989"/>
          <a:stretch/>
        </p:blipFill>
        <p:spPr>
          <a:xfrm>
            <a:off x="2427729" y="6575264"/>
            <a:ext cx="1775460" cy="4149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2" name="그림 81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67" t="18101" r="20564" b="69524"/>
          <a:stretch/>
        </p:blipFill>
        <p:spPr>
          <a:xfrm>
            <a:off x="4579620" y="3554205"/>
            <a:ext cx="2278380" cy="4876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3" name="그림 82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057" t="16899" r="17979" b="76164"/>
          <a:stretch/>
        </p:blipFill>
        <p:spPr>
          <a:xfrm>
            <a:off x="2348719" y="3589729"/>
            <a:ext cx="1529519" cy="47051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5" name="그림 84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683" t="25308" r="42490" b="42003"/>
          <a:stretch/>
        </p:blipFill>
        <p:spPr>
          <a:xfrm>
            <a:off x="5140118" y="4249436"/>
            <a:ext cx="1409700" cy="18973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6" name="그림 85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04" t="47364" r="28598" b="46487"/>
          <a:stretch/>
        </p:blipFill>
        <p:spPr>
          <a:xfrm>
            <a:off x="4679305" y="2218130"/>
            <a:ext cx="1729740" cy="4953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7" name="그림 86"/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01" t="17717" r="22902" b="79122"/>
          <a:stretch/>
        </p:blipFill>
        <p:spPr>
          <a:xfrm>
            <a:off x="4553049" y="2858794"/>
            <a:ext cx="1912620" cy="29117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9" name="그림 88"/>
          <p:cNvPicPr preferRelativeResize="0"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64" t="9450" r="38383" b="81274"/>
          <a:stretch/>
        </p:blipFill>
        <p:spPr>
          <a:xfrm>
            <a:off x="588418" y="3452569"/>
            <a:ext cx="1181100" cy="5181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0" name="그림 89"/>
          <p:cNvPicPr preferRelativeResize="0"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92" t="62055" r="39190" b="32672"/>
          <a:stretch/>
        </p:blipFill>
        <p:spPr>
          <a:xfrm>
            <a:off x="565175" y="4786539"/>
            <a:ext cx="1127760" cy="3733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1" name="그림 90"/>
          <p:cNvPicPr preferRelativeResize="0"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321" t="69825" r="18473" b="27293"/>
          <a:stretch/>
        </p:blipFill>
        <p:spPr>
          <a:xfrm>
            <a:off x="453353" y="5400568"/>
            <a:ext cx="1325880" cy="2971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2" name="그림 91"/>
          <p:cNvPicPr preferRelativeResize="0">
            <a:picLocks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19" t="52408" r="39518" b="41386"/>
          <a:stretch/>
        </p:blipFill>
        <p:spPr>
          <a:xfrm>
            <a:off x="459023" y="4287954"/>
            <a:ext cx="1348740" cy="3194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3" name="그림 92"/>
          <p:cNvPicPr preferRelativeResize="0">
            <a:picLocks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60" t="46212" r="5715" b="44633"/>
          <a:stretch/>
        </p:blipFill>
        <p:spPr>
          <a:xfrm>
            <a:off x="2038515" y="5821392"/>
            <a:ext cx="2476499" cy="6553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4" name="그림 93"/>
          <p:cNvPicPr preferRelativeResize="0">
            <a:picLocks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52" t="19625" r="29326" b="71093"/>
          <a:stretch/>
        </p:blipFill>
        <p:spPr>
          <a:xfrm>
            <a:off x="4720689" y="420610"/>
            <a:ext cx="1744980" cy="63246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5" name="직사각형 94"/>
          <p:cNvSpPr/>
          <p:nvPr/>
        </p:nvSpPr>
        <p:spPr>
          <a:xfrm>
            <a:off x="5864134" y="393979"/>
            <a:ext cx="514593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6" name="직사각형 95"/>
          <p:cNvSpPr/>
          <p:nvPr/>
        </p:nvSpPr>
        <p:spPr>
          <a:xfrm>
            <a:off x="1214295" y="3452569"/>
            <a:ext cx="514593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7" name="직사각형 96"/>
          <p:cNvSpPr/>
          <p:nvPr/>
        </p:nvSpPr>
        <p:spPr>
          <a:xfrm>
            <a:off x="2829452" y="3584631"/>
            <a:ext cx="514593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8" name="직사각형 97"/>
          <p:cNvSpPr/>
          <p:nvPr/>
        </p:nvSpPr>
        <p:spPr>
          <a:xfrm>
            <a:off x="5390902" y="3537847"/>
            <a:ext cx="500257" cy="5503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9" name="직사각형 98"/>
          <p:cNvSpPr/>
          <p:nvPr/>
        </p:nvSpPr>
        <p:spPr>
          <a:xfrm>
            <a:off x="1020223" y="4193048"/>
            <a:ext cx="514593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0" name="직사각형 99"/>
          <p:cNvSpPr/>
          <p:nvPr/>
        </p:nvSpPr>
        <p:spPr>
          <a:xfrm>
            <a:off x="5322724" y="5461333"/>
            <a:ext cx="514593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1" name="직사각형 100"/>
          <p:cNvSpPr/>
          <p:nvPr/>
        </p:nvSpPr>
        <p:spPr>
          <a:xfrm>
            <a:off x="5790733" y="2197118"/>
            <a:ext cx="514593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2" name="직사각형 101"/>
          <p:cNvSpPr/>
          <p:nvPr/>
        </p:nvSpPr>
        <p:spPr>
          <a:xfrm>
            <a:off x="1116303" y="4737303"/>
            <a:ext cx="514593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3" name="직사각형 102"/>
          <p:cNvSpPr/>
          <p:nvPr/>
        </p:nvSpPr>
        <p:spPr>
          <a:xfrm>
            <a:off x="3126064" y="5894417"/>
            <a:ext cx="514593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5" name="직사각형 104"/>
          <p:cNvSpPr/>
          <p:nvPr/>
        </p:nvSpPr>
        <p:spPr>
          <a:xfrm>
            <a:off x="5861584" y="2711977"/>
            <a:ext cx="514593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6" name="직사각형 105"/>
          <p:cNvSpPr/>
          <p:nvPr/>
        </p:nvSpPr>
        <p:spPr>
          <a:xfrm>
            <a:off x="1066579" y="5312125"/>
            <a:ext cx="514593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7" name="직사각형 106"/>
          <p:cNvSpPr/>
          <p:nvPr/>
        </p:nvSpPr>
        <p:spPr>
          <a:xfrm>
            <a:off x="3162025" y="6480957"/>
            <a:ext cx="514593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8" name="직사각형 107"/>
          <p:cNvSpPr/>
          <p:nvPr/>
        </p:nvSpPr>
        <p:spPr>
          <a:xfrm>
            <a:off x="5129742" y="6730497"/>
            <a:ext cx="514593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04" name="그림 103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63" t="22867" r="41770" b="41600"/>
          <a:stretch/>
        </p:blipFill>
        <p:spPr>
          <a:xfrm>
            <a:off x="2420989" y="4201046"/>
            <a:ext cx="1194816" cy="145694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9" name="직사각형 108"/>
          <p:cNvSpPr/>
          <p:nvPr/>
        </p:nvSpPr>
        <p:spPr>
          <a:xfrm>
            <a:off x="2977825" y="5130048"/>
            <a:ext cx="445982" cy="3312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10" name="그림 109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402" t="49063" r="22463" b="43505"/>
          <a:stretch/>
        </p:blipFill>
        <p:spPr>
          <a:xfrm>
            <a:off x="5112552" y="6263686"/>
            <a:ext cx="1196807" cy="30475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1" name="직사각형 110"/>
          <p:cNvSpPr/>
          <p:nvPr/>
        </p:nvSpPr>
        <p:spPr>
          <a:xfrm>
            <a:off x="5200931" y="6308054"/>
            <a:ext cx="500257" cy="3006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12" name="그림 111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61" t="58853" r="40759" b="19738"/>
          <a:stretch/>
        </p:blipFill>
        <p:spPr>
          <a:xfrm>
            <a:off x="4897317" y="1199779"/>
            <a:ext cx="1487425" cy="8778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3" name="직사각형 112"/>
          <p:cNvSpPr/>
          <p:nvPr/>
        </p:nvSpPr>
        <p:spPr>
          <a:xfrm>
            <a:off x="5103744" y="1552010"/>
            <a:ext cx="514593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62935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179079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93855" y="808814"/>
            <a:ext cx="2860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직선 연결선 4"/>
          <p:cNvCxnSpPr/>
          <p:nvPr/>
        </p:nvCxnSpPr>
        <p:spPr>
          <a:xfrm flipH="1">
            <a:off x="907195" y="1101006"/>
            <a:ext cx="467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839054" y="879764"/>
            <a:ext cx="620571" cy="2148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935843" y="1256920"/>
            <a:ext cx="122145" cy="201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249272" y="1095511"/>
            <a:ext cx="122145" cy="201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244662" y="1256920"/>
            <a:ext cx="122145" cy="201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935843" y="1095511"/>
            <a:ext cx="122145" cy="201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35228" y="1087160"/>
            <a:ext cx="679456" cy="2148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siCT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57128" y="1254833"/>
            <a:ext cx="757556" cy="2148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i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467624" y="1526930"/>
            <a:ext cx="762552" cy="2148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463494" y="2084036"/>
            <a:ext cx="631506" cy="2148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92388" y="1826906"/>
            <a:ext cx="730096" cy="1745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92388" y="2187309"/>
            <a:ext cx="730096" cy="1745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17359" y="1529943"/>
            <a:ext cx="705125" cy="1745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그림 17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991" t="12190" r="24845" b="84610"/>
          <a:stretch/>
        </p:blipFill>
        <p:spPr>
          <a:xfrm>
            <a:off x="833517" y="1489193"/>
            <a:ext cx="648000" cy="2512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그림 18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487" t="43250" r="20375" b="52878"/>
          <a:stretch/>
        </p:blipFill>
        <p:spPr>
          <a:xfrm>
            <a:off x="833517" y="1791540"/>
            <a:ext cx="648000" cy="2512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그림 19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557" t="19622" r="25661" b="77358"/>
          <a:stretch/>
        </p:blipFill>
        <p:spPr>
          <a:xfrm>
            <a:off x="833517" y="2077739"/>
            <a:ext cx="648000" cy="25126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" name="TextBox 20"/>
          <p:cNvSpPr txBox="1"/>
          <p:nvPr/>
        </p:nvSpPr>
        <p:spPr>
          <a:xfrm>
            <a:off x="1467624" y="1787974"/>
            <a:ext cx="631506" cy="2148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그림 21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925" t="11080" r="24844" b="84610"/>
          <a:stretch/>
        </p:blipFill>
        <p:spPr>
          <a:xfrm>
            <a:off x="203765" y="2732600"/>
            <a:ext cx="1503908" cy="33837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그림 22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309" t="43198" r="20375" b="52878"/>
          <a:stretch/>
        </p:blipFill>
        <p:spPr>
          <a:xfrm>
            <a:off x="426372" y="3403442"/>
            <a:ext cx="1351508" cy="2546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그림 23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365" t="19438" r="25660" b="77358"/>
          <a:stretch/>
        </p:blipFill>
        <p:spPr>
          <a:xfrm>
            <a:off x="301722" y="3816961"/>
            <a:ext cx="1483588" cy="26651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직사각형 24"/>
          <p:cNvSpPr/>
          <p:nvPr/>
        </p:nvSpPr>
        <p:spPr>
          <a:xfrm>
            <a:off x="999177" y="2556712"/>
            <a:ext cx="684390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6" name="직사각형 25"/>
          <p:cNvSpPr/>
          <p:nvPr/>
        </p:nvSpPr>
        <p:spPr>
          <a:xfrm>
            <a:off x="1069384" y="3138342"/>
            <a:ext cx="684390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7" name="직사각형 26"/>
          <p:cNvSpPr/>
          <p:nvPr/>
        </p:nvSpPr>
        <p:spPr>
          <a:xfrm>
            <a:off x="1093490" y="3711968"/>
            <a:ext cx="684390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8" name="TextBox 27"/>
          <p:cNvSpPr txBox="1"/>
          <p:nvPr/>
        </p:nvSpPr>
        <p:spPr>
          <a:xfrm>
            <a:off x="2478276" y="633842"/>
            <a:ext cx="418840" cy="2685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200577" y="679386"/>
            <a:ext cx="1537731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ep3B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562593" y="1164478"/>
            <a:ext cx="861722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i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700234" y="988886"/>
            <a:ext cx="724081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siCT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직선 연결선 32"/>
          <p:cNvCxnSpPr/>
          <p:nvPr/>
        </p:nvCxnSpPr>
        <p:spPr>
          <a:xfrm flipH="1">
            <a:off x="3403182" y="944993"/>
            <a:ext cx="11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3480290" y="1137977"/>
            <a:ext cx="184330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799437" y="975550"/>
            <a:ext cx="184330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799437" y="1147705"/>
            <a:ext cx="184330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480290" y="985278"/>
            <a:ext cx="184330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2513906" y="1329628"/>
            <a:ext cx="910409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cDNA3.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4418519" y="1305420"/>
            <a:ext cx="184330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117826" y="1305420"/>
            <a:ext cx="184330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799437" y="1317816"/>
            <a:ext cx="184330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480290" y="1317816"/>
            <a:ext cx="184330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4117826" y="1138949"/>
            <a:ext cx="184330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4410899" y="980052"/>
            <a:ext cx="184330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410899" y="1154875"/>
            <a:ext cx="184330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117826" y="985278"/>
            <a:ext cx="184330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2501101" y="1498753"/>
            <a:ext cx="910409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4405713" y="1497105"/>
            <a:ext cx="184330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105021" y="1497105"/>
            <a:ext cx="184330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3786631" y="1497105"/>
            <a:ext cx="184330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467485" y="1497105"/>
            <a:ext cx="184330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4702249" y="1757568"/>
            <a:ext cx="830953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702249" y="2094744"/>
            <a:ext cx="830953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4702249" y="2422193"/>
            <a:ext cx="767009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5" name="그림 54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958" t="43217" r="7674" b="53944"/>
          <a:stretch/>
        </p:blipFill>
        <p:spPr>
          <a:xfrm>
            <a:off x="3359153" y="1737175"/>
            <a:ext cx="1332000" cy="2834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6" name="그림 55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764" t="57674" r="6311" b="37866"/>
          <a:stretch/>
        </p:blipFill>
        <p:spPr>
          <a:xfrm>
            <a:off x="3359153" y="2063962"/>
            <a:ext cx="1332000" cy="2834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7" name="그림 56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678" t="51306" r="6769" b="45596"/>
          <a:stretch/>
        </p:blipFill>
        <p:spPr>
          <a:xfrm>
            <a:off x="3359153" y="2390748"/>
            <a:ext cx="1332000" cy="28343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8" name="TextBox 57"/>
          <p:cNvSpPr txBox="1"/>
          <p:nvPr/>
        </p:nvSpPr>
        <p:spPr>
          <a:xfrm>
            <a:off x="2553128" y="2129084"/>
            <a:ext cx="883416" cy="1627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2553128" y="2512273"/>
            <a:ext cx="883416" cy="1627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2583343" y="1808298"/>
            <a:ext cx="853201" cy="1627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1" name="그림 60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786" t="36594" r="5545" b="48853"/>
          <a:stretch/>
        </p:blipFill>
        <p:spPr>
          <a:xfrm>
            <a:off x="3030367" y="2885291"/>
            <a:ext cx="1767840" cy="14528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2" name="그림 61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201" t="55874" r="4335" b="32934"/>
          <a:stretch/>
        </p:blipFill>
        <p:spPr>
          <a:xfrm>
            <a:off x="3177313" y="4405214"/>
            <a:ext cx="1513840" cy="711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3" name="그림 62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748" t="49482" r="4626" b="43188"/>
          <a:stretch/>
        </p:blipFill>
        <p:spPr>
          <a:xfrm>
            <a:off x="3173169" y="5183458"/>
            <a:ext cx="1544319" cy="67056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4" name="직사각형 63"/>
          <p:cNvSpPr/>
          <p:nvPr/>
        </p:nvSpPr>
        <p:spPr>
          <a:xfrm>
            <a:off x="3192563" y="3448376"/>
            <a:ext cx="1498590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5" name="직사각형 64"/>
          <p:cNvSpPr/>
          <p:nvPr/>
        </p:nvSpPr>
        <p:spPr>
          <a:xfrm>
            <a:off x="3173169" y="4459389"/>
            <a:ext cx="1498590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6" name="직사각형 65"/>
          <p:cNvSpPr/>
          <p:nvPr/>
        </p:nvSpPr>
        <p:spPr>
          <a:xfrm>
            <a:off x="3184938" y="5265629"/>
            <a:ext cx="1498590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7" name="TextBox 66"/>
          <p:cNvSpPr txBox="1"/>
          <p:nvPr/>
        </p:nvSpPr>
        <p:spPr>
          <a:xfrm>
            <a:off x="382646" y="4778551"/>
            <a:ext cx="418840" cy="2536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437452" y="5307111"/>
            <a:ext cx="685127" cy="202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ip5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475742" y="5135781"/>
            <a:ext cx="646837" cy="202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siCT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209038" y="5284916"/>
            <a:ext cx="152339" cy="202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520470" y="5132759"/>
            <a:ext cx="152339" cy="202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1520470" y="5284916"/>
            <a:ext cx="152339" cy="202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1209038" y="5132759"/>
            <a:ext cx="152339" cy="202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1116949" y="4913542"/>
            <a:ext cx="652148" cy="202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직선 연결선 75"/>
          <p:cNvCxnSpPr/>
          <p:nvPr/>
        </p:nvCxnSpPr>
        <p:spPr>
          <a:xfrm flipH="1">
            <a:off x="1129164" y="5129271"/>
            <a:ext cx="64119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7" name="그림 76"/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1122579" y="6094643"/>
            <a:ext cx="648000" cy="2373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8" name="그림 77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42" t="28926" r="73148" b="67357"/>
          <a:stretch/>
        </p:blipFill>
        <p:spPr>
          <a:xfrm>
            <a:off x="1122579" y="5507426"/>
            <a:ext cx="648000" cy="2373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9" name="그림 78"/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84" t="64814" r="73723" b="31780"/>
          <a:stretch/>
        </p:blipFill>
        <p:spPr>
          <a:xfrm>
            <a:off x="1122579" y="5801034"/>
            <a:ext cx="648000" cy="23738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0" name="TextBox 79"/>
          <p:cNvSpPr txBox="1"/>
          <p:nvPr/>
        </p:nvSpPr>
        <p:spPr>
          <a:xfrm>
            <a:off x="1772190" y="5512041"/>
            <a:ext cx="686738" cy="202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1772190" y="5799710"/>
            <a:ext cx="686738" cy="202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1772190" y="6076912"/>
            <a:ext cx="633892" cy="202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319613" y="5850598"/>
            <a:ext cx="883416" cy="164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327198" y="6170118"/>
            <a:ext cx="883416" cy="164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366868" y="5604761"/>
            <a:ext cx="853201" cy="164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7" name="그림 86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98" t="24748" r="3290" b="64858"/>
          <a:stretch/>
        </p:blipFill>
        <p:spPr>
          <a:xfrm>
            <a:off x="576196" y="6776582"/>
            <a:ext cx="4171167" cy="66387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8" name="그림 87"/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31" t="60619" r="12017" b="30023"/>
          <a:stretch/>
        </p:blipFill>
        <p:spPr>
          <a:xfrm>
            <a:off x="658411" y="7590890"/>
            <a:ext cx="3601034" cy="65227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9" name="직사각형 88"/>
          <p:cNvSpPr/>
          <p:nvPr/>
        </p:nvSpPr>
        <p:spPr>
          <a:xfrm>
            <a:off x="880369" y="6943802"/>
            <a:ext cx="684390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0" name="직사각형 89"/>
          <p:cNvSpPr/>
          <p:nvPr/>
        </p:nvSpPr>
        <p:spPr>
          <a:xfrm>
            <a:off x="859225" y="7729449"/>
            <a:ext cx="684390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91" name="그림 90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03" t="35968" r="10263" b="57342"/>
          <a:stretch/>
        </p:blipFill>
        <p:spPr>
          <a:xfrm>
            <a:off x="637597" y="8412097"/>
            <a:ext cx="3780922" cy="47461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2" name="직사각형 91"/>
          <p:cNvSpPr/>
          <p:nvPr/>
        </p:nvSpPr>
        <p:spPr>
          <a:xfrm>
            <a:off x="819950" y="8440298"/>
            <a:ext cx="744809" cy="3652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75726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179079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45821" y="577117"/>
            <a:ext cx="389268" cy="250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724994" y="832896"/>
            <a:ext cx="12708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0" y="1309175"/>
            <a:ext cx="7121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i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13753" y="1101315"/>
            <a:ext cx="5984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siCT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직선 연결선 7"/>
          <p:cNvCxnSpPr/>
          <p:nvPr/>
        </p:nvCxnSpPr>
        <p:spPr>
          <a:xfrm flipH="1">
            <a:off x="715567" y="1082797"/>
            <a:ext cx="124949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798626" y="1282248"/>
            <a:ext cx="152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129514" y="1097649"/>
            <a:ext cx="152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129514" y="1282248"/>
            <a:ext cx="152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83128" y="1098770"/>
            <a:ext cx="3792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49015" y="1499614"/>
            <a:ext cx="5631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ip5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795376" y="1467166"/>
            <a:ext cx="152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445439" y="1467166"/>
            <a:ext cx="152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129514" y="1467166"/>
            <a:ext cx="152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98626" y="1467166"/>
            <a:ext cx="152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445439" y="1276938"/>
            <a:ext cx="152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795376" y="1092339"/>
            <a:ext cx="152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795376" y="1276938"/>
            <a:ext cx="152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445439" y="1097649"/>
            <a:ext cx="152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그림 21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951" t="28597" r="8537" b="65943"/>
          <a:stretch/>
        </p:blipFill>
        <p:spPr>
          <a:xfrm>
            <a:off x="702134" y="2097946"/>
            <a:ext cx="129600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그림 22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339" t="7254" r="8788" b="89145"/>
          <a:stretch/>
        </p:blipFill>
        <p:spPr>
          <a:xfrm>
            <a:off x="702134" y="1746214"/>
            <a:ext cx="129600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4" name="TextBox 23"/>
          <p:cNvSpPr txBox="1"/>
          <p:nvPr/>
        </p:nvSpPr>
        <p:spPr>
          <a:xfrm>
            <a:off x="1995846" y="1768748"/>
            <a:ext cx="6867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995846" y="2126530"/>
            <a:ext cx="6867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984787" y="2448379"/>
            <a:ext cx="6338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그림 26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63" t="20420" r="16787" b="77150"/>
          <a:stretch/>
        </p:blipFill>
        <p:spPr>
          <a:xfrm>
            <a:off x="702134" y="2448379"/>
            <a:ext cx="129600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8" name="TextBox 27"/>
          <p:cNvSpPr txBox="1"/>
          <p:nvPr/>
        </p:nvSpPr>
        <p:spPr>
          <a:xfrm>
            <a:off x="274459" y="2180726"/>
            <a:ext cx="52096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74459" y="2565349"/>
            <a:ext cx="52096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62106" y="1839512"/>
            <a:ext cx="62210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그림 30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949" t="19891" r="5434" b="59686"/>
          <a:stretch/>
        </p:blipFill>
        <p:spPr>
          <a:xfrm>
            <a:off x="191818" y="3958889"/>
            <a:ext cx="1741117" cy="10772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그림 31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790" t="6068" r="4452" b="87995"/>
          <a:stretch/>
        </p:blipFill>
        <p:spPr>
          <a:xfrm>
            <a:off x="313149" y="3256724"/>
            <a:ext cx="1741118" cy="47479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그림 32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541" t="17605" r="13084" b="74890"/>
          <a:stretch/>
        </p:blipFill>
        <p:spPr>
          <a:xfrm>
            <a:off x="363254" y="5098093"/>
            <a:ext cx="1640909" cy="88934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5" name="TextBox 34"/>
          <p:cNvSpPr txBox="1"/>
          <p:nvPr/>
        </p:nvSpPr>
        <p:spPr>
          <a:xfrm>
            <a:off x="2680714" y="2267182"/>
            <a:ext cx="14815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RGS/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His-UBE2M 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704287" y="1738712"/>
            <a:ext cx="792961" cy="1627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588554" y="827449"/>
            <a:ext cx="701785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ep3B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576490" y="1430565"/>
            <a:ext cx="816474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53 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098865" y="1260106"/>
            <a:ext cx="1294098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RGS/His 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직선 연결선 39"/>
          <p:cNvCxnSpPr/>
          <p:nvPr/>
        </p:nvCxnSpPr>
        <p:spPr>
          <a:xfrm flipH="1">
            <a:off x="4465622" y="1057925"/>
            <a:ext cx="97028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3519048" y="1049336"/>
            <a:ext cx="873916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cDNA3.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4531746" y="1235004"/>
            <a:ext cx="135408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4700218" y="1064485"/>
            <a:ext cx="379887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4825298" y="1235004"/>
            <a:ext cx="135408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398610" y="1064485"/>
            <a:ext cx="426674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+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5126617" y="1428425"/>
            <a:ext cx="135408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4825298" y="1428425"/>
            <a:ext cx="135408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4531746" y="1428425"/>
            <a:ext cx="135408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5126617" y="1235004"/>
            <a:ext cx="135408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5126617" y="1064485"/>
            <a:ext cx="135408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5360000" y="1699325"/>
            <a:ext cx="692845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5360000" y="2335756"/>
            <a:ext cx="692845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5360000" y="2641576"/>
            <a:ext cx="713041" cy="200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2851176" y="2398339"/>
            <a:ext cx="1311068" cy="1752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Endo UBE2M 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5" name="그림 54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656" t="24184" r="9400" b="72410"/>
          <a:stretch/>
        </p:blipFill>
        <p:spPr>
          <a:xfrm>
            <a:off x="4407187" y="2604389"/>
            <a:ext cx="936830" cy="26352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6" name="그림 55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245" t="40525" r="9045" b="52412"/>
          <a:stretch/>
        </p:blipFill>
        <p:spPr>
          <a:xfrm>
            <a:off x="4407188" y="2298616"/>
            <a:ext cx="936830" cy="26352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7" name="그림 56"/>
          <p:cNvPicPr preferRelativeResize="0">
            <a:picLocks/>
          </p:cNvPicPr>
          <p:nvPr/>
        </p:nvPicPr>
        <p:blipFill rotWithShape="1">
          <a:blip r:embed="rId6"/>
          <a:srcRect r="25175"/>
          <a:stretch/>
        </p:blipFill>
        <p:spPr>
          <a:xfrm>
            <a:off x="4409214" y="1987393"/>
            <a:ext cx="936830" cy="26352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8" name="그림 57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862" t="18610" r="9057" b="78370"/>
          <a:stretch/>
        </p:blipFill>
        <p:spPr>
          <a:xfrm>
            <a:off x="4409214" y="1675239"/>
            <a:ext cx="936830" cy="26352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9" name="TextBox 58"/>
          <p:cNvSpPr txBox="1"/>
          <p:nvPr/>
        </p:nvSpPr>
        <p:spPr>
          <a:xfrm>
            <a:off x="3671941" y="2734058"/>
            <a:ext cx="821043" cy="1627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3700022" y="2055179"/>
            <a:ext cx="792961" cy="1627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5360000" y="1978577"/>
            <a:ext cx="13834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53 </a:t>
            </a: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(Long exposure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3700022" y="2426031"/>
            <a:ext cx="792961" cy="1627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3458032" y="716919"/>
            <a:ext cx="418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4" name="그림 63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024" t="22838" r="2176" b="70847"/>
          <a:stretch/>
        </p:blipFill>
        <p:spPr>
          <a:xfrm>
            <a:off x="4162243" y="5063199"/>
            <a:ext cx="1352811" cy="4885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5" name="그림 64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549" t="36194" r="991" b="51385"/>
          <a:stretch/>
        </p:blipFill>
        <p:spPr>
          <a:xfrm>
            <a:off x="4096010" y="4393731"/>
            <a:ext cx="1377862" cy="46346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6" name="그림 65"/>
          <p:cNvPicPr preferRelativeResize="0">
            <a:picLocks/>
          </p:cNvPicPr>
          <p:nvPr/>
        </p:nvPicPr>
        <p:blipFill rotWithShape="1">
          <a:blip r:embed="rId6"/>
          <a:srcRect l="-3002" t="-14259" r="-8762" b="-47102"/>
          <a:stretch/>
        </p:blipFill>
        <p:spPr>
          <a:xfrm>
            <a:off x="4085285" y="3968510"/>
            <a:ext cx="1399313" cy="42522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7" name="그림 66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695" t="17133" r="2772" b="75689"/>
          <a:stretch/>
        </p:blipFill>
        <p:spPr>
          <a:xfrm>
            <a:off x="4133589" y="3206663"/>
            <a:ext cx="1302707" cy="62630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8" name="직사각형 67"/>
          <p:cNvSpPr/>
          <p:nvPr/>
        </p:nvSpPr>
        <p:spPr>
          <a:xfrm>
            <a:off x="499317" y="3227699"/>
            <a:ext cx="1433617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9" name="직사각형 68"/>
          <p:cNvSpPr/>
          <p:nvPr/>
        </p:nvSpPr>
        <p:spPr>
          <a:xfrm>
            <a:off x="412705" y="4276924"/>
            <a:ext cx="1433617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0" name="직사각형 69"/>
          <p:cNvSpPr/>
          <p:nvPr/>
        </p:nvSpPr>
        <p:spPr>
          <a:xfrm>
            <a:off x="440184" y="5354162"/>
            <a:ext cx="1433617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1" name="직사각형 70"/>
          <p:cNvSpPr/>
          <p:nvPr/>
        </p:nvSpPr>
        <p:spPr>
          <a:xfrm>
            <a:off x="4133589" y="3289437"/>
            <a:ext cx="1048841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2" name="직사각형 71"/>
          <p:cNvSpPr/>
          <p:nvPr/>
        </p:nvSpPr>
        <p:spPr>
          <a:xfrm>
            <a:off x="4064110" y="3917279"/>
            <a:ext cx="1048841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3" name="직사각형 72"/>
          <p:cNvSpPr/>
          <p:nvPr/>
        </p:nvSpPr>
        <p:spPr>
          <a:xfrm>
            <a:off x="4065203" y="4431585"/>
            <a:ext cx="1048841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4" name="직사각형 73"/>
          <p:cNvSpPr/>
          <p:nvPr/>
        </p:nvSpPr>
        <p:spPr>
          <a:xfrm>
            <a:off x="4142733" y="5045511"/>
            <a:ext cx="1048841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6" name="TextBox 75"/>
          <p:cNvSpPr txBox="1"/>
          <p:nvPr/>
        </p:nvSpPr>
        <p:spPr>
          <a:xfrm>
            <a:off x="2389830" y="8074483"/>
            <a:ext cx="654009" cy="2004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2389830" y="7766763"/>
            <a:ext cx="654009" cy="2004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461392" y="7042438"/>
            <a:ext cx="712167" cy="187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1514255" y="7042438"/>
            <a:ext cx="152339" cy="187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1752925" y="7042438"/>
            <a:ext cx="321570" cy="187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2154476" y="7042438"/>
            <a:ext cx="152339" cy="187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1198805" y="7042438"/>
            <a:ext cx="152339" cy="187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2389830" y="7293214"/>
            <a:ext cx="654009" cy="2004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113753" y="6890752"/>
            <a:ext cx="1059806" cy="187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RGS/His UBE2M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351495" y="6722202"/>
            <a:ext cx="822064" cy="187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pcDNA3.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1200794" y="6706674"/>
            <a:ext cx="152339" cy="187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1513975" y="6706674"/>
            <a:ext cx="152339" cy="187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1833506" y="6687624"/>
            <a:ext cx="152339" cy="187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2146687" y="6687624"/>
            <a:ext cx="152339" cy="187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1204686" y="6880477"/>
            <a:ext cx="152339" cy="187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1517867" y="6880477"/>
            <a:ext cx="152339" cy="187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1837398" y="6880477"/>
            <a:ext cx="152339" cy="187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2150579" y="6880477"/>
            <a:ext cx="152339" cy="187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4" name="그림 93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476" t="50107" r="38693" b="46873"/>
          <a:stretch/>
        </p:blipFill>
        <p:spPr>
          <a:xfrm>
            <a:off x="1090973" y="7282321"/>
            <a:ext cx="1296000" cy="2344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5" name="그림 94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64" t="55793" r="36924" b="40181"/>
          <a:stretch/>
        </p:blipFill>
        <p:spPr>
          <a:xfrm>
            <a:off x="1090973" y="8077242"/>
            <a:ext cx="1296000" cy="2344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6" name="그림 95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07" t="67011" r="35807" b="26113"/>
          <a:stretch/>
        </p:blipFill>
        <p:spPr>
          <a:xfrm>
            <a:off x="1090973" y="7737278"/>
            <a:ext cx="1296000" cy="2931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7" name="TextBox 96"/>
          <p:cNvSpPr txBox="1"/>
          <p:nvPr/>
        </p:nvSpPr>
        <p:spPr>
          <a:xfrm>
            <a:off x="1102515" y="7515001"/>
            <a:ext cx="30522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1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1376068" y="7515001"/>
            <a:ext cx="4043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1.58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1697935" y="7515001"/>
            <a:ext cx="4043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1.07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2027423" y="7515001"/>
            <a:ext cx="4043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1.04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454994" y="8189554"/>
            <a:ext cx="719702" cy="162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35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454994" y="7357403"/>
            <a:ext cx="719702" cy="162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5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454994" y="7755190"/>
            <a:ext cx="719702" cy="162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2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105004" y="6369297"/>
            <a:ext cx="418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AC4BE883-55CB-4966-AAF2-7314F0876649}"/>
              </a:ext>
            </a:extLst>
          </p:cNvPr>
          <p:cNvSpPr txBox="1"/>
          <p:nvPr/>
        </p:nvSpPr>
        <p:spPr>
          <a:xfrm>
            <a:off x="1047668" y="6450009"/>
            <a:ext cx="12708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6" name="직선 연결선 105"/>
          <p:cNvCxnSpPr/>
          <p:nvPr/>
        </p:nvCxnSpPr>
        <p:spPr>
          <a:xfrm flipH="1">
            <a:off x="1144489" y="6696230"/>
            <a:ext cx="11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7" name="그림 106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606" t="45625" r="32608" b="44049"/>
          <a:stretch/>
        </p:blipFill>
        <p:spPr>
          <a:xfrm>
            <a:off x="3771427" y="6795843"/>
            <a:ext cx="1728591" cy="8016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8" name="그림 107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118" t="53515" r="33593" b="35087"/>
          <a:stretch/>
        </p:blipFill>
        <p:spPr>
          <a:xfrm>
            <a:off x="3921854" y="8244475"/>
            <a:ext cx="1490597" cy="6638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9" name="그림 108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74" t="62471" r="33375" b="24012"/>
          <a:stretch/>
        </p:blipFill>
        <p:spPr>
          <a:xfrm>
            <a:off x="3824442" y="7574030"/>
            <a:ext cx="1528175" cy="57619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0" name="직사각형 109"/>
          <p:cNvSpPr/>
          <p:nvPr/>
        </p:nvSpPr>
        <p:spPr>
          <a:xfrm>
            <a:off x="3872400" y="6974447"/>
            <a:ext cx="1487600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1" name="직사각형 110"/>
          <p:cNvSpPr/>
          <p:nvPr/>
        </p:nvSpPr>
        <p:spPr>
          <a:xfrm>
            <a:off x="3824442" y="7715056"/>
            <a:ext cx="1487600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2" name="직사각형 111"/>
          <p:cNvSpPr/>
          <p:nvPr/>
        </p:nvSpPr>
        <p:spPr>
          <a:xfrm>
            <a:off x="3891840" y="8304940"/>
            <a:ext cx="1487600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53438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179079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52914" y="1314681"/>
            <a:ext cx="712167" cy="187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직선 연결선 4"/>
          <p:cNvCxnSpPr/>
          <p:nvPr/>
        </p:nvCxnSpPr>
        <p:spPr>
          <a:xfrm>
            <a:off x="1638867" y="1329894"/>
            <a:ext cx="5943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844433" y="1094947"/>
            <a:ext cx="758923" cy="187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shCTL</a:t>
            </a:r>
            <a:endParaRPr lang="ko-KR" altLang="en-US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322352" y="1330363"/>
            <a:ext cx="152339" cy="187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671360" y="1326039"/>
            <a:ext cx="152339" cy="187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033392" y="1328319"/>
            <a:ext cx="152339" cy="187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033775" y="1329341"/>
            <a:ext cx="152339" cy="187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537297" y="1100996"/>
            <a:ext cx="780040" cy="187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shUBE2M</a:t>
            </a:r>
            <a:endParaRPr lang="ko-KR" altLang="en-US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직선 연결선 11"/>
          <p:cNvCxnSpPr/>
          <p:nvPr/>
        </p:nvCxnSpPr>
        <p:spPr>
          <a:xfrm>
            <a:off x="895509" y="1328897"/>
            <a:ext cx="5943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2227229" y="2141588"/>
            <a:ext cx="654009" cy="2004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227229" y="1850695"/>
            <a:ext cx="654009" cy="2004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227229" y="1569326"/>
            <a:ext cx="654009" cy="2004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그림 15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1" t="55701" r="68742" b="41140"/>
          <a:stretch/>
        </p:blipFill>
        <p:spPr>
          <a:xfrm>
            <a:off x="921743" y="2138686"/>
            <a:ext cx="1296000" cy="2344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그림 16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1" t="69915" r="69849" b="25811"/>
          <a:stretch/>
        </p:blipFill>
        <p:spPr>
          <a:xfrm>
            <a:off x="921743" y="1850476"/>
            <a:ext cx="1296000" cy="2344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그림 17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1" t="48491" r="70999" b="46630"/>
          <a:stretch/>
        </p:blipFill>
        <p:spPr>
          <a:xfrm>
            <a:off x="921743" y="1557366"/>
            <a:ext cx="1296000" cy="23448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TextBox 18"/>
          <p:cNvSpPr txBox="1"/>
          <p:nvPr/>
        </p:nvSpPr>
        <p:spPr>
          <a:xfrm>
            <a:off x="282707" y="2223496"/>
            <a:ext cx="719702" cy="162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35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82707" y="1642538"/>
            <a:ext cx="719702" cy="162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5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82707" y="1846281"/>
            <a:ext cx="719702" cy="162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2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45556" y="683790"/>
            <a:ext cx="418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909CE00-7D1E-4EAE-9D93-9110D2B8FB5C}"/>
              </a:ext>
            </a:extLst>
          </p:cNvPr>
          <p:cNvSpPr txBox="1"/>
          <p:nvPr/>
        </p:nvSpPr>
        <p:spPr>
          <a:xfrm>
            <a:off x="923677" y="854497"/>
            <a:ext cx="12708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그림 23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9" t="47088" r="66231" b="39414"/>
          <a:stretch/>
        </p:blipFill>
        <p:spPr>
          <a:xfrm>
            <a:off x="3018773" y="2342057"/>
            <a:ext cx="1465545" cy="100208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그림 24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09" t="65567" r="68148" b="19592"/>
          <a:stretch/>
        </p:blipFill>
        <p:spPr>
          <a:xfrm>
            <a:off x="2931090" y="1420009"/>
            <a:ext cx="1603332" cy="81419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그림 25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4" t="44217" r="68535" b="37277"/>
          <a:stretch/>
        </p:blipFill>
        <p:spPr>
          <a:xfrm>
            <a:off x="2931090" y="375782"/>
            <a:ext cx="1553228" cy="88934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" name="직사각형 26"/>
          <p:cNvSpPr/>
          <p:nvPr/>
        </p:nvSpPr>
        <p:spPr>
          <a:xfrm>
            <a:off x="2988956" y="486856"/>
            <a:ext cx="1487600" cy="39819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8" name="직사각형 27"/>
          <p:cNvSpPr/>
          <p:nvPr/>
        </p:nvSpPr>
        <p:spPr>
          <a:xfrm>
            <a:off x="3046822" y="1548437"/>
            <a:ext cx="1487600" cy="39819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9" name="직사각형 28"/>
          <p:cNvSpPr/>
          <p:nvPr/>
        </p:nvSpPr>
        <p:spPr>
          <a:xfrm>
            <a:off x="2988956" y="2843098"/>
            <a:ext cx="1487600" cy="39819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0" name="TextBox 29"/>
          <p:cNvSpPr txBox="1"/>
          <p:nvPr/>
        </p:nvSpPr>
        <p:spPr>
          <a:xfrm>
            <a:off x="2612628" y="4363322"/>
            <a:ext cx="4465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직선 연결선 30"/>
          <p:cNvCxnSpPr/>
          <p:nvPr/>
        </p:nvCxnSpPr>
        <p:spPr>
          <a:xfrm>
            <a:off x="579806" y="4099575"/>
            <a:ext cx="94682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/>
          <p:cNvCxnSpPr/>
          <p:nvPr/>
        </p:nvCxnSpPr>
        <p:spPr>
          <a:xfrm>
            <a:off x="1626620" y="4099569"/>
            <a:ext cx="104150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-229244" y="4119701"/>
            <a:ext cx="8054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CHX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95375" y="3868178"/>
            <a:ext cx="934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siCT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695181" y="3868178"/>
            <a:ext cx="9111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i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62759" y="4094211"/>
            <a:ext cx="2865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765706" y="4094211"/>
            <a:ext cx="3490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031913" y="4094211"/>
            <a:ext cx="3425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307588" y="4094211"/>
            <a:ext cx="3329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563312" y="4094211"/>
            <a:ext cx="303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1804708" y="4094211"/>
            <a:ext cx="3490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095196" y="4094211"/>
            <a:ext cx="3319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357892" y="4094211"/>
            <a:ext cx="3372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4" name="그림 43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573400" y="4650805"/>
            <a:ext cx="2059913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5" name="그림 44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18" t="44942" r="87111" b="16603"/>
          <a:stretch/>
        </p:blipFill>
        <p:spPr>
          <a:xfrm rot="5400000">
            <a:off x="1459356" y="3439561"/>
            <a:ext cx="288000" cy="20599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6" name="그림 45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886" t="44483" r="47843" b="17652"/>
          <a:stretch/>
        </p:blipFill>
        <p:spPr>
          <a:xfrm rot="5400000">
            <a:off x="1459356" y="4086634"/>
            <a:ext cx="288000" cy="205991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7" name="TextBox 46"/>
          <p:cNvSpPr txBox="1"/>
          <p:nvPr/>
        </p:nvSpPr>
        <p:spPr>
          <a:xfrm>
            <a:off x="2638227" y="4089861"/>
            <a:ext cx="6412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min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1122359" y="3657353"/>
            <a:ext cx="934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49265" y="4725574"/>
            <a:ext cx="501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149265" y="5089420"/>
            <a:ext cx="501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95741" y="4402985"/>
            <a:ext cx="55469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643905" y="4961716"/>
            <a:ext cx="614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2628402" y="4648899"/>
            <a:ext cx="6300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77683" y="3581933"/>
            <a:ext cx="260624" cy="3057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3533235" y="3683195"/>
            <a:ext cx="341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직선 연결선 55"/>
          <p:cNvCxnSpPr/>
          <p:nvPr/>
        </p:nvCxnSpPr>
        <p:spPr>
          <a:xfrm>
            <a:off x="3939274" y="4168630"/>
            <a:ext cx="9437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직선 연결선 56"/>
          <p:cNvCxnSpPr/>
          <p:nvPr/>
        </p:nvCxnSpPr>
        <p:spPr>
          <a:xfrm>
            <a:off x="4982732" y="4168624"/>
            <a:ext cx="10381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3506059" y="4154550"/>
            <a:ext cx="484519" cy="247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HX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3954793" y="3937233"/>
            <a:ext cx="9315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siCT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5051074" y="3937233"/>
            <a:ext cx="9081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i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3947066" y="4163266"/>
            <a:ext cx="3072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4154767" y="4163266"/>
            <a:ext cx="3743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4419558" y="4163266"/>
            <a:ext cx="3673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4693523" y="4163266"/>
            <a:ext cx="3570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4945887" y="4163266"/>
            <a:ext cx="3255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5190438" y="4163266"/>
            <a:ext cx="3743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5478516" y="4163266"/>
            <a:ext cx="3559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5740836" y="4163266"/>
            <a:ext cx="3617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5991098" y="4158915"/>
            <a:ext cx="5530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min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5992402" y="5110381"/>
            <a:ext cx="6904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5992401" y="4753580"/>
            <a:ext cx="6904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5994164" y="4394939"/>
            <a:ext cx="5767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4558080" y="3789741"/>
            <a:ext cx="9315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CT116</a:t>
            </a:r>
            <a:r>
              <a:rPr lang="en-US" altLang="ko-K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p53+/+</a:t>
            </a:r>
            <a:endParaRPr lang="ko-KR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4" name="그림 73"/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3973238" y="4402985"/>
            <a:ext cx="205331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5" name="그림 74"/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3973238" y="4721474"/>
            <a:ext cx="205331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6" name="그림 75"/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85" t="67219" r="33543" b="29838"/>
          <a:stretch/>
        </p:blipFill>
        <p:spPr>
          <a:xfrm>
            <a:off x="3973238" y="5039963"/>
            <a:ext cx="205331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7" name="TextBox 76"/>
          <p:cNvSpPr txBox="1"/>
          <p:nvPr/>
        </p:nvSpPr>
        <p:spPr>
          <a:xfrm>
            <a:off x="3413646" y="4802699"/>
            <a:ext cx="632388" cy="2007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3413646" y="5170838"/>
            <a:ext cx="632388" cy="2007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3435277" y="4443084"/>
            <a:ext cx="610758" cy="2007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1" name="그림 80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06" t="43717" r="76069" b="15127"/>
          <a:stretch/>
        </p:blipFill>
        <p:spPr>
          <a:xfrm rot="5400000">
            <a:off x="803533" y="5598290"/>
            <a:ext cx="1189974" cy="22045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2" name="그림 81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490" t="42818" r="42234" b="14356"/>
          <a:stretch/>
        </p:blipFill>
        <p:spPr>
          <a:xfrm rot="5400000">
            <a:off x="1069433" y="7263131"/>
            <a:ext cx="889346" cy="232984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3" name="직사각형 82"/>
          <p:cNvSpPr/>
          <p:nvPr/>
        </p:nvSpPr>
        <p:spPr>
          <a:xfrm>
            <a:off x="338423" y="6278982"/>
            <a:ext cx="2088674" cy="3473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4" name="직사각형 83"/>
          <p:cNvSpPr/>
          <p:nvPr/>
        </p:nvSpPr>
        <p:spPr>
          <a:xfrm>
            <a:off x="403284" y="8172637"/>
            <a:ext cx="2203014" cy="4202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87" name="그림 86"/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15" t="65617" r="31568" b="28239"/>
          <a:stretch/>
        </p:blipFill>
        <p:spPr>
          <a:xfrm>
            <a:off x="3609013" y="7404008"/>
            <a:ext cx="2342367" cy="60124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8" name="직사각형 87"/>
          <p:cNvSpPr/>
          <p:nvPr/>
        </p:nvSpPr>
        <p:spPr>
          <a:xfrm>
            <a:off x="3678689" y="7447640"/>
            <a:ext cx="2203014" cy="4202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90" name="그림 89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97" t="4134" r="32886" b="85013"/>
          <a:stretch/>
        </p:blipFill>
        <p:spPr>
          <a:xfrm>
            <a:off x="3947066" y="6811099"/>
            <a:ext cx="1676400" cy="44500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1" name="직사각형 90"/>
          <p:cNvSpPr/>
          <p:nvPr/>
        </p:nvSpPr>
        <p:spPr>
          <a:xfrm>
            <a:off x="3993816" y="6832045"/>
            <a:ext cx="1570925" cy="27204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92" name="그림 91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5496" b="87096"/>
          <a:stretch/>
        </p:blipFill>
        <p:spPr>
          <a:xfrm>
            <a:off x="3664176" y="6015465"/>
            <a:ext cx="2170294" cy="59697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3" name="직사각형 92"/>
          <p:cNvSpPr/>
          <p:nvPr/>
        </p:nvSpPr>
        <p:spPr>
          <a:xfrm>
            <a:off x="3933380" y="6234155"/>
            <a:ext cx="1870610" cy="2696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95" name="그림 94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735" t="16741" r="9889" b="16059"/>
          <a:stretch/>
        </p:blipFill>
        <p:spPr>
          <a:xfrm rot="5400000">
            <a:off x="1491706" y="6231081"/>
            <a:ext cx="518160" cy="275539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6" name="직사각형 95"/>
          <p:cNvSpPr/>
          <p:nvPr/>
        </p:nvSpPr>
        <p:spPr>
          <a:xfrm>
            <a:off x="412136" y="7444243"/>
            <a:ext cx="1644816" cy="3473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974817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179079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124943" y="604486"/>
            <a:ext cx="418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544384" y="1376361"/>
            <a:ext cx="6252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siCT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직선 연결선 91"/>
          <p:cNvCxnSpPr/>
          <p:nvPr/>
        </p:nvCxnSpPr>
        <p:spPr>
          <a:xfrm flipH="1">
            <a:off x="1109059" y="1390525"/>
            <a:ext cx="5785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직선 연결선 92"/>
          <p:cNvCxnSpPr/>
          <p:nvPr/>
        </p:nvCxnSpPr>
        <p:spPr>
          <a:xfrm flipH="1">
            <a:off x="1792871" y="1390525"/>
            <a:ext cx="59496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Box 93"/>
          <p:cNvSpPr txBox="1"/>
          <p:nvPr/>
        </p:nvSpPr>
        <p:spPr>
          <a:xfrm>
            <a:off x="1727737" y="1149274"/>
            <a:ext cx="6892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Nucleu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449822" y="1584221"/>
            <a:ext cx="7197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i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1096357" y="1569723"/>
            <a:ext cx="26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1451736" y="1373596"/>
            <a:ext cx="26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1448215" y="1569723"/>
            <a:ext cx="26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1096357" y="1373596"/>
            <a:ext cx="26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1806848" y="1569723"/>
            <a:ext cx="26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2153611" y="1373596"/>
            <a:ext cx="26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2150090" y="1569723"/>
            <a:ext cx="26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1806848" y="1373596"/>
            <a:ext cx="26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2424002" y="2735071"/>
            <a:ext cx="6243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2424002" y="2371790"/>
            <a:ext cx="6243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DM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2424002" y="1865484"/>
            <a:ext cx="6243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2424002" y="3082561"/>
            <a:ext cx="7973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Lamin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A/C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2424002" y="3372901"/>
            <a:ext cx="8636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9" name="그림 108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16" t="55899" r="60918" b="39145"/>
          <a:stretch/>
        </p:blipFill>
        <p:spPr>
          <a:xfrm>
            <a:off x="1064736" y="2685366"/>
            <a:ext cx="1361991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0" name="그림 109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688" t="25336" r="20013" b="70947"/>
          <a:stretch/>
        </p:blipFill>
        <p:spPr>
          <a:xfrm>
            <a:off x="1064736" y="1865484"/>
            <a:ext cx="1361991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1" name="그림 110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1064736" y="2357098"/>
            <a:ext cx="1361991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2" name="그림 111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429" t="30454" r="24942" b="65713"/>
          <a:stretch/>
        </p:blipFill>
        <p:spPr>
          <a:xfrm>
            <a:off x="1064736" y="3013634"/>
            <a:ext cx="1361991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3" name="그림 112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31" t="32471" r="57790" b="64510"/>
          <a:stretch/>
        </p:blipFill>
        <p:spPr>
          <a:xfrm>
            <a:off x="1064736" y="3341903"/>
            <a:ext cx="1361991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4" name="TextBox 113"/>
          <p:cNvSpPr txBox="1"/>
          <p:nvPr/>
        </p:nvSpPr>
        <p:spPr>
          <a:xfrm>
            <a:off x="556899" y="3262023"/>
            <a:ext cx="59207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577150" y="2716457"/>
            <a:ext cx="57182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556899" y="1929368"/>
            <a:ext cx="59207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577150" y="2514591"/>
            <a:ext cx="57182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577150" y="2952056"/>
            <a:ext cx="57182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직선 연결선 118"/>
          <p:cNvCxnSpPr/>
          <p:nvPr/>
        </p:nvCxnSpPr>
        <p:spPr>
          <a:xfrm flipH="1">
            <a:off x="1091681" y="2183767"/>
            <a:ext cx="5785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직선 연결선 119"/>
          <p:cNvCxnSpPr/>
          <p:nvPr/>
        </p:nvCxnSpPr>
        <p:spPr>
          <a:xfrm flipH="1">
            <a:off x="1745745" y="2183767"/>
            <a:ext cx="65446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20"/>
          <p:cNvSpPr txBox="1"/>
          <p:nvPr/>
        </p:nvSpPr>
        <p:spPr>
          <a:xfrm>
            <a:off x="1151709" y="2165479"/>
            <a:ext cx="1554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1336242" y="2166205"/>
            <a:ext cx="3847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2.85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1673381" y="2166205"/>
            <a:ext cx="3847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2052685" y="2166205"/>
            <a:ext cx="3847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1.42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1080131" y="1150747"/>
            <a:ext cx="6555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ytoso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1259749" y="860414"/>
            <a:ext cx="10201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HepG2 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3" name="그림 172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11" t="52010" r="56096" b="33331"/>
          <a:stretch/>
        </p:blipFill>
        <p:spPr>
          <a:xfrm>
            <a:off x="124943" y="6092101"/>
            <a:ext cx="1929008" cy="8517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4" name="그림 173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107" t="22531" r="17515" b="67770"/>
          <a:stretch/>
        </p:blipFill>
        <p:spPr>
          <a:xfrm>
            <a:off x="156402" y="4218012"/>
            <a:ext cx="1728592" cy="75156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6" name="그림 175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342" t="24746" r="19847" b="61418"/>
          <a:stretch/>
        </p:blipFill>
        <p:spPr>
          <a:xfrm>
            <a:off x="137786" y="7113544"/>
            <a:ext cx="1716066" cy="10396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7" name="그림 176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94" t="28599" r="55795" b="60897"/>
          <a:stretch/>
        </p:blipFill>
        <p:spPr>
          <a:xfrm>
            <a:off x="225798" y="8481472"/>
            <a:ext cx="1741118" cy="100208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4" name="직사각형 183"/>
          <p:cNvSpPr/>
          <p:nvPr/>
        </p:nvSpPr>
        <p:spPr>
          <a:xfrm>
            <a:off x="156402" y="4323358"/>
            <a:ext cx="1650446" cy="4010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5" name="직사각형 184"/>
          <p:cNvSpPr/>
          <p:nvPr/>
        </p:nvSpPr>
        <p:spPr>
          <a:xfrm>
            <a:off x="344374" y="6248062"/>
            <a:ext cx="1650446" cy="4010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6" name="직사각형 185"/>
          <p:cNvSpPr/>
          <p:nvPr/>
        </p:nvSpPr>
        <p:spPr>
          <a:xfrm>
            <a:off x="130229" y="7466908"/>
            <a:ext cx="1650446" cy="4010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7" name="직사각형 186"/>
          <p:cNvSpPr/>
          <p:nvPr/>
        </p:nvSpPr>
        <p:spPr>
          <a:xfrm>
            <a:off x="283836" y="8827290"/>
            <a:ext cx="1650446" cy="4010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88" name="그림 187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43000" contrast="7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4564" t="18798" r="4946" b="61337"/>
          <a:stretch/>
        </p:blipFill>
        <p:spPr>
          <a:xfrm>
            <a:off x="4494269" y="8005306"/>
            <a:ext cx="1540702" cy="789140"/>
          </a:xfrm>
          <a:prstGeom prst="rect">
            <a:avLst/>
          </a:prstGeom>
          <a:pattFill prst="pct5">
            <a:fgClr>
              <a:schemeClr val="accent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</p:pic>
      <p:pic>
        <p:nvPicPr>
          <p:cNvPr id="189" name="그림 188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761" t="70340" r="1974" b="23324"/>
          <a:stretch/>
        </p:blipFill>
        <p:spPr>
          <a:xfrm>
            <a:off x="4446738" y="9045142"/>
            <a:ext cx="1528176" cy="4384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0" name="그림 189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5000" contrast="8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400" t="66697" r="47298" b="13622"/>
          <a:stretch/>
        </p:blipFill>
        <p:spPr>
          <a:xfrm>
            <a:off x="4425377" y="5273633"/>
            <a:ext cx="1678486" cy="170473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1" name="그림 190"/>
          <p:cNvPicPr preferRelativeResize="0">
            <a:picLocks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917" t="76956" r="15149" b="13078"/>
          <a:stretch/>
        </p:blipFill>
        <p:spPr>
          <a:xfrm>
            <a:off x="4433474" y="7215737"/>
            <a:ext cx="1678487" cy="62630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2" name="직사각형 191"/>
          <p:cNvSpPr/>
          <p:nvPr/>
        </p:nvSpPr>
        <p:spPr>
          <a:xfrm>
            <a:off x="5282420" y="5339160"/>
            <a:ext cx="752551" cy="16667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3" name="직사각형 192"/>
          <p:cNvSpPr/>
          <p:nvPr/>
        </p:nvSpPr>
        <p:spPr>
          <a:xfrm>
            <a:off x="5425056" y="7318345"/>
            <a:ext cx="609915" cy="4561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4" name="직사각형 193"/>
          <p:cNvSpPr/>
          <p:nvPr/>
        </p:nvSpPr>
        <p:spPr>
          <a:xfrm>
            <a:off x="5292296" y="8224490"/>
            <a:ext cx="609915" cy="4561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5" name="직사각형 194"/>
          <p:cNvSpPr/>
          <p:nvPr/>
        </p:nvSpPr>
        <p:spPr>
          <a:xfrm>
            <a:off x="5272717" y="9045142"/>
            <a:ext cx="609915" cy="4561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90" name="그림 89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07" t="5616" r="54123" b="79797"/>
          <a:stretch/>
        </p:blipFill>
        <p:spPr>
          <a:xfrm rot="21369358">
            <a:off x="315668" y="5093853"/>
            <a:ext cx="1835869" cy="94502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2" name="직사각형 131"/>
          <p:cNvSpPr/>
          <p:nvPr/>
        </p:nvSpPr>
        <p:spPr>
          <a:xfrm>
            <a:off x="556899" y="5569063"/>
            <a:ext cx="1455897" cy="2778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3" name="TextBox 132"/>
          <p:cNvSpPr txBox="1"/>
          <p:nvPr/>
        </p:nvSpPr>
        <p:spPr>
          <a:xfrm>
            <a:off x="3638346" y="1525882"/>
            <a:ext cx="13281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RGS/His-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4283916" y="3537484"/>
            <a:ext cx="7051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4283916" y="4212520"/>
            <a:ext cx="7051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4215914" y="1129484"/>
            <a:ext cx="7121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DM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4103768" y="904690"/>
            <a:ext cx="8243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lag-p5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4175677" y="1319923"/>
            <a:ext cx="7524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A-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5293929" y="1333522"/>
            <a:ext cx="152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4969393" y="1333522"/>
            <a:ext cx="152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4969393" y="1106223"/>
            <a:ext cx="152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5293929" y="904690"/>
            <a:ext cx="152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5293929" y="1106223"/>
            <a:ext cx="152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4969393" y="910000"/>
            <a:ext cx="152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5293929" y="1530770"/>
            <a:ext cx="152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/>
          <p:cNvSpPr txBox="1"/>
          <p:nvPr/>
        </p:nvSpPr>
        <p:spPr>
          <a:xfrm>
            <a:off x="4969393" y="1530770"/>
            <a:ext cx="152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Box 174"/>
          <p:cNvSpPr txBox="1"/>
          <p:nvPr/>
        </p:nvSpPr>
        <p:spPr>
          <a:xfrm>
            <a:off x="5537485" y="3058300"/>
            <a:ext cx="68673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IB: Flag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/>
          <p:cNvSpPr txBox="1"/>
          <p:nvPr/>
        </p:nvSpPr>
        <p:spPr>
          <a:xfrm>
            <a:off x="5538784" y="3430686"/>
            <a:ext cx="6338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IB: Flag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9" name="직선 연결선 178"/>
          <p:cNvCxnSpPr/>
          <p:nvPr/>
        </p:nvCxnSpPr>
        <p:spPr>
          <a:xfrm flipV="1">
            <a:off x="4515925" y="1789313"/>
            <a:ext cx="0" cy="1525736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0" name="TextBox 179"/>
          <p:cNvSpPr txBox="1"/>
          <p:nvPr/>
        </p:nvSpPr>
        <p:spPr>
          <a:xfrm rot="16200000">
            <a:off x="4131790" y="2532642"/>
            <a:ext cx="5159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IP: H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1" name="직선 연결선 180"/>
          <p:cNvCxnSpPr/>
          <p:nvPr/>
        </p:nvCxnSpPr>
        <p:spPr>
          <a:xfrm rot="5400000" flipH="1">
            <a:off x="4046540" y="3877658"/>
            <a:ext cx="938768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2" name="TextBox 181"/>
          <p:cNvSpPr txBox="1"/>
          <p:nvPr/>
        </p:nvSpPr>
        <p:spPr>
          <a:xfrm rot="16200000">
            <a:off x="4105122" y="3779358"/>
            <a:ext cx="5159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/>
          <p:cNvSpPr txBox="1"/>
          <p:nvPr/>
        </p:nvSpPr>
        <p:spPr>
          <a:xfrm>
            <a:off x="5538784" y="3785851"/>
            <a:ext cx="8392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IB: UBE2M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TextBox 195"/>
          <p:cNvSpPr txBox="1"/>
          <p:nvPr/>
        </p:nvSpPr>
        <p:spPr>
          <a:xfrm>
            <a:off x="5538784" y="4122158"/>
            <a:ext cx="8392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l-GR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7" name="그림 196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43000" contrast="7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9576" t="26046" r="7347" b="64747"/>
          <a:stretch/>
        </p:blipFill>
        <p:spPr>
          <a:xfrm>
            <a:off x="4907484" y="3681521"/>
            <a:ext cx="630000" cy="365759"/>
          </a:xfrm>
          <a:prstGeom prst="rect">
            <a:avLst/>
          </a:prstGeom>
          <a:pattFill prst="pct5">
            <a:fgClr>
              <a:schemeClr val="accent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</p:pic>
      <p:pic>
        <p:nvPicPr>
          <p:cNvPr id="198" name="그림 197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594" t="71823" r="4560" b="24541"/>
          <a:stretch/>
        </p:blipFill>
        <p:spPr>
          <a:xfrm>
            <a:off x="4907485" y="4076210"/>
            <a:ext cx="630000" cy="2515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9" name="그림 198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5000" contrast="8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026" t="69740" r="49032" b="13622"/>
          <a:stretch/>
        </p:blipFill>
        <p:spPr>
          <a:xfrm>
            <a:off x="4907485" y="1820527"/>
            <a:ext cx="630000" cy="14411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0" name="그림 199"/>
          <p:cNvPicPr preferRelativeResize="0">
            <a:picLocks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9947" t="79748" r="16424" b="16624"/>
          <a:stretch/>
        </p:blipFill>
        <p:spPr>
          <a:xfrm>
            <a:off x="4907485" y="3420858"/>
            <a:ext cx="630000" cy="2280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1" name="TextBox 200"/>
          <p:cNvSpPr txBox="1"/>
          <p:nvPr/>
        </p:nvSpPr>
        <p:spPr>
          <a:xfrm>
            <a:off x="4283916" y="3127889"/>
            <a:ext cx="705125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Box 201"/>
          <p:cNvSpPr txBox="1"/>
          <p:nvPr/>
        </p:nvSpPr>
        <p:spPr>
          <a:xfrm>
            <a:off x="3784913" y="287808"/>
            <a:ext cx="418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TextBox 202"/>
          <p:cNvSpPr txBox="1"/>
          <p:nvPr/>
        </p:nvSpPr>
        <p:spPr>
          <a:xfrm>
            <a:off x="4165094" y="712488"/>
            <a:ext cx="7641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cDNA3.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TextBox 203"/>
          <p:cNvSpPr txBox="1"/>
          <p:nvPr/>
        </p:nvSpPr>
        <p:spPr>
          <a:xfrm>
            <a:off x="5295051" y="712488"/>
            <a:ext cx="152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TextBox 204"/>
          <p:cNvSpPr txBox="1"/>
          <p:nvPr/>
        </p:nvSpPr>
        <p:spPr>
          <a:xfrm>
            <a:off x="4970515" y="717798"/>
            <a:ext cx="152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TextBox 205"/>
          <p:cNvSpPr txBox="1"/>
          <p:nvPr/>
        </p:nvSpPr>
        <p:spPr>
          <a:xfrm>
            <a:off x="4712195" y="495566"/>
            <a:ext cx="10201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TextBox 206"/>
          <p:cNvSpPr txBox="1"/>
          <p:nvPr/>
        </p:nvSpPr>
        <p:spPr>
          <a:xfrm>
            <a:off x="4283916" y="3821750"/>
            <a:ext cx="7051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016814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179079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직선 연결선 3"/>
          <p:cNvCxnSpPr/>
          <p:nvPr/>
        </p:nvCxnSpPr>
        <p:spPr>
          <a:xfrm flipH="1">
            <a:off x="625456" y="991266"/>
            <a:ext cx="13930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927539" y="724233"/>
            <a:ext cx="7997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580727" y="1220186"/>
            <a:ext cx="3923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113648" y="1220186"/>
            <a:ext cx="6201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85578" y="1219067"/>
            <a:ext cx="5375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012996" y="2558421"/>
            <a:ext cx="8621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B: 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012996" y="1883738"/>
            <a:ext cx="9794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B: MDM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958075" y="1220186"/>
            <a:ext cx="3175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P: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012996" y="1534031"/>
            <a:ext cx="8621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B: p5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7451" y="2621328"/>
            <a:ext cx="71970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2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4277" y="1780827"/>
            <a:ext cx="71970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10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4277" y="1554786"/>
            <a:ext cx="71970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5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241232" y="1016470"/>
            <a:ext cx="1204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813721" y="1016470"/>
            <a:ext cx="1204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667110" y="1016470"/>
            <a:ext cx="1204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979090" y="1023429"/>
            <a:ext cx="11912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G132 (20 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그림 19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88" t="23341" r="49639" b="74104"/>
          <a:stretch/>
        </p:blipFill>
        <p:spPr>
          <a:xfrm>
            <a:off x="675782" y="1482757"/>
            <a:ext cx="129600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그림 20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675782" y="2546561"/>
            <a:ext cx="129600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그림 21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798" t="14704" r="35385" b="81394"/>
          <a:stretch/>
        </p:blipFill>
        <p:spPr>
          <a:xfrm>
            <a:off x="675782" y="2191959"/>
            <a:ext cx="129600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TextBox 22"/>
          <p:cNvSpPr txBox="1"/>
          <p:nvPr/>
        </p:nvSpPr>
        <p:spPr>
          <a:xfrm>
            <a:off x="2023589" y="2186085"/>
            <a:ext cx="12037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B: MDM2</a:t>
            </a: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(Longer exposure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그림 23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28" t="14883" r="35831" b="81554"/>
          <a:stretch/>
        </p:blipFill>
        <p:spPr>
          <a:xfrm>
            <a:off x="675782" y="1837358"/>
            <a:ext cx="129600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TextBox 24"/>
          <p:cNvSpPr txBox="1"/>
          <p:nvPr/>
        </p:nvSpPr>
        <p:spPr>
          <a:xfrm>
            <a:off x="0" y="638808"/>
            <a:ext cx="418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그림 25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62" t="20836" r="48301" b="70496"/>
          <a:stretch/>
        </p:blipFill>
        <p:spPr>
          <a:xfrm>
            <a:off x="372087" y="3093863"/>
            <a:ext cx="1640909" cy="9770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그림 27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97" t="4445" r="25384" b="75698"/>
          <a:stretch/>
        </p:blipFill>
        <p:spPr>
          <a:xfrm>
            <a:off x="14316" y="5457003"/>
            <a:ext cx="2379946" cy="14655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그림 28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02" t="8336" r="31599" b="76945"/>
          <a:stretch/>
        </p:blipFill>
        <p:spPr>
          <a:xfrm>
            <a:off x="208309" y="4168961"/>
            <a:ext cx="2054269" cy="118997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0" name="TextBox 29"/>
          <p:cNvSpPr txBox="1"/>
          <p:nvPr/>
        </p:nvSpPr>
        <p:spPr>
          <a:xfrm>
            <a:off x="3413545" y="125241"/>
            <a:ext cx="418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4538891" y="1678470"/>
            <a:ext cx="71970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2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그림 32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62" t="63709" r="66441" b="31850"/>
          <a:stretch/>
        </p:blipFill>
        <p:spPr>
          <a:xfrm>
            <a:off x="5170501" y="1227820"/>
            <a:ext cx="64800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그림 33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02" t="76717" r="66601" b="18842"/>
          <a:stretch/>
        </p:blipFill>
        <p:spPr>
          <a:xfrm>
            <a:off x="5170501" y="1879602"/>
            <a:ext cx="64800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그림 34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80" t="86758" r="66324" b="6505"/>
          <a:stretch/>
        </p:blipFill>
        <p:spPr>
          <a:xfrm>
            <a:off x="5170501" y="1553711"/>
            <a:ext cx="64800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6" name="TextBox 35"/>
          <p:cNvSpPr txBox="1"/>
          <p:nvPr/>
        </p:nvSpPr>
        <p:spPr>
          <a:xfrm>
            <a:off x="5062813" y="315582"/>
            <a:ext cx="8680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043384" y="747098"/>
            <a:ext cx="12257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RGS/His-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458801" y="541354"/>
            <a:ext cx="8103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cDNA3.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직선 연결선 38"/>
          <p:cNvCxnSpPr/>
          <p:nvPr/>
        </p:nvCxnSpPr>
        <p:spPr>
          <a:xfrm flipH="1">
            <a:off x="5228692" y="533707"/>
            <a:ext cx="5299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4069628" y="956587"/>
            <a:ext cx="11995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DM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5572949" y="535575"/>
            <a:ext cx="1523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5572949" y="737108"/>
            <a:ext cx="1523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5572949" y="959097"/>
            <a:ext cx="1523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5283989" y="533065"/>
            <a:ext cx="1523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5283989" y="734598"/>
            <a:ext cx="1523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5283989" y="956587"/>
            <a:ext cx="1523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5777098" y="1273175"/>
            <a:ext cx="616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DM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5777098" y="1915812"/>
            <a:ext cx="6340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5777098" y="1594494"/>
            <a:ext cx="6340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3635322" y="1485211"/>
            <a:ext cx="131742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RGS/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His-UBE2M 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786902" y="1632027"/>
            <a:ext cx="11658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Endo UBE2M 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4540261" y="1326523"/>
            <a:ext cx="71970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7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540261" y="2017733"/>
            <a:ext cx="71970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35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직사각형 53"/>
          <p:cNvSpPr/>
          <p:nvPr/>
        </p:nvSpPr>
        <p:spPr>
          <a:xfrm>
            <a:off x="549409" y="3215084"/>
            <a:ext cx="1429681" cy="5377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5" name="직사각형 54"/>
          <p:cNvSpPr/>
          <p:nvPr/>
        </p:nvSpPr>
        <p:spPr>
          <a:xfrm>
            <a:off x="683090" y="4582555"/>
            <a:ext cx="1429681" cy="5377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6" name="직사각형 55"/>
          <p:cNvSpPr/>
          <p:nvPr/>
        </p:nvSpPr>
        <p:spPr>
          <a:xfrm>
            <a:off x="616249" y="6031538"/>
            <a:ext cx="1429681" cy="5377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58" name="그림 57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74" t="53801" r="60708" b="25137"/>
          <a:stretch/>
        </p:blipFill>
        <p:spPr>
          <a:xfrm>
            <a:off x="3994347" y="2741826"/>
            <a:ext cx="1365811" cy="13658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9" name="그림 58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92" t="71520" r="66212" b="17769"/>
          <a:stretch/>
        </p:blipFill>
        <p:spPr>
          <a:xfrm>
            <a:off x="4241011" y="5598621"/>
            <a:ext cx="821802" cy="6944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0" name="그림 59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39" t="76899" r="64194" b="3063"/>
          <a:stretch/>
        </p:blipFill>
        <p:spPr>
          <a:xfrm>
            <a:off x="3935391" y="4335683"/>
            <a:ext cx="1319514" cy="85652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7" name="직사각형 56"/>
          <p:cNvSpPr/>
          <p:nvPr/>
        </p:nvSpPr>
        <p:spPr>
          <a:xfrm>
            <a:off x="4149132" y="3313512"/>
            <a:ext cx="1021370" cy="5377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2" name="직사각형 61"/>
          <p:cNvSpPr/>
          <p:nvPr/>
        </p:nvSpPr>
        <p:spPr>
          <a:xfrm>
            <a:off x="4196680" y="4631677"/>
            <a:ext cx="1021370" cy="5377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3" name="직사각형 62"/>
          <p:cNvSpPr/>
          <p:nvPr/>
        </p:nvSpPr>
        <p:spPr>
          <a:xfrm>
            <a:off x="4141227" y="5762673"/>
            <a:ext cx="1021370" cy="5377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61" name="그림 60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84" t="35293" r="47619" b="44264"/>
          <a:stretch/>
        </p:blipFill>
        <p:spPr>
          <a:xfrm>
            <a:off x="654155" y="7077982"/>
            <a:ext cx="1028700" cy="83820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4" name="직사각형 63"/>
          <p:cNvSpPr/>
          <p:nvPr/>
        </p:nvSpPr>
        <p:spPr>
          <a:xfrm>
            <a:off x="683090" y="7473567"/>
            <a:ext cx="999765" cy="2226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220371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-39248" y="179284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066723" y="1081426"/>
            <a:ext cx="12482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79814" y="1620446"/>
            <a:ext cx="8423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i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77497" y="1362440"/>
            <a:ext cx="6447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siCT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직선 연결선 6"/>
          <p:cNvCxnSpPr/>
          <p:nvPr/>
        </p:nvCxnSpPr>
        <p:spPr>
          <a:xfrm flipH="1">
            <a:off x="1010000" y="1354117"/>
            <a:ext cx="13392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137577" y="1626593"/>
            <a:ext cx="134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484176" y="1363429"/>
            <a:ext cx="134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484176" y="1626593"/>
            <a:ext cx="134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137577" y="1372144"/>
            <a:ext cx="134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57866" y="1875233"/>
            <a:ext cx="5665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iL1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183635" y="1865583"/>
            <a:ext cx="134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849702" y="1865583"/>
            <a:ext cx="134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486352" y="1870893"/>
            <a:ext cx="134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139752" y="1870893"/>
            <a:ext cx="134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847527" y="1623188"/>
            <a:ext cx="134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181460" y="1363429"/>
            <a:ext cx="134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176367" y="1623188"/>
            <a:ext cx="134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847527" y="1363429"/>
            <a:ext cx="134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504982" y="2550578"/>
            <a:ext cx="690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L1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504982" y="2220578"/>
            <a:ext cx="5131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504982" y="2880578"/>
            <a:ext cx="7105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504982" y="3210578"/>
            <a:ext cx="7105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그림 24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409" t="80509" r="28839" b="16064"/>
          <a:stretch/>
        </p:blipFill>
        <p:spPr>
          <a:xfrm>
            <a:off x="1048861" y="3137736"/>
            <a:ext cx="1452415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그림 25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571" t="72635" r="22682" b="23029"/>
          <a:stretch/>
        </p:blipFill>
        <p:spPr>
          <a:xfrm>
            <a:off x="1048861" y="2179358"/>
            <a:ext cx="1452415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그림 26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761" t="84683" r="25349" b="11229"/>
          <a:stretch/>
        </p:blipFill>
        <p:spPr>
          <a:xfrm>
            <a:off x="1048861" y="2498817"/>
            <a:ext cx="1452415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그림 27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1048861" y="2817224"/>
            <a:ext cx="1452415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9" name="TextBox 28"/>
          <p:cNvSpPr txBox="1"/>
          <p:nvPr/>
        </p:nvSpPr>
        <p:spPr>
          <a:xfrm>
            <a:off x="343883" y="3275263"/>
            <a:ext cx="8065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35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40326" y="2514772"/>
            <a:ext cx="8065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35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40326" y="2197291"/>
            <a:ext cx="8065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5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43883" y="2850783"/>
            <a:ext cx="8065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2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71731" y="769460"/>
            <a:ext cx="4693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085259" y="775967"/>
            <a:ext cx="418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그림 35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908" t="61288" r="13825" b="35537"/>
          <a:stretch/>
        </p:blipFill>
        <p:spPr>
          <a:xfrm>
            <a:off x="4658518" y="3197957"/>
            <a:ext cx="745261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그림 36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70" t="75100" r="74375" b="21590"/>
          <a:stretch/>
        </p:blipFill>
        <p:spPr>
          <a:xfrm>
            <a:off x="4658518" y="1727705"/>
            <a:ext cx="745261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그림 37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80" t="75187" r="53996" b="21561"/>
          <a:stretch/>
        </p:blipFill>
        <p:spPr>
          <a:xfrm>
            <a:off x="4658518" y="2462831"/>
            <a:ext cx="745261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그림 38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503" t="79226" r="33767" b="15721"/>
          <a:stretch/>
        </p:blipFill>
        <p:spPr>
          <a:xfrm>
            <a:off x="4658518" y="2095268"/>
            <a:ext cx="745261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그림 39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926" t="78162" r="14327" b="17749"/>
          <a:stretch/>
        </p:blipFill>
        <p:spPr>
          <a:xfrm>
            <a:off x="4658518" y="2830394"/>
            <a:ext cx="745261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1" name="TextBox 40"/>
          <p:cNvSpPr txBox="1"/>
          <p:nvPr/>
        </p:nvSpPr>
        <p:spPr>
          <a:xfrm>
            <a:off x="4528073" y="816703"/>
            <a:ext cx="9982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355634" y="1257744"/>
            <a:ext cx="14097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RGS/His-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833403" y="1032950"/>
            <a:ext cx="9319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cDNA3.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직선 연결선 43"/>
          <p:cNvCxnSpPr/>
          <p:nvPr/>
        </p:nvCxnSpPr>
        <p:spPr>
          <a:xfrm flipH="1">
            <a:off x="4718850" y="1032736"/>
            <a:ext cx="6094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3385817" y="1448183"/>
            <a:ext cx="13795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lag-L1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5114778" y="1027171"/>
            <a:ext cx="1752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5114778" y="1228704"/>
            <a:ext cx="1752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5114778" y="1450693"/>
            <a:ext cx="1752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782446" y="1024661"/>
            <a:ext cx="1752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4782446" y="1226194"/>
            <a:ext cx="1752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4782446" y="1448183"/>
            <a:ext cx="1752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5378484" y="1732641"/>
            <a:ext cx="8992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B :Flag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직선 연결선 52"/>
          <p:cNvCxnSpPr/>
          <p:nvPr/>
        </p:nvCxnSpPr>
        <p:spPr>
          <a:xfrm rot="5400000" flipH="1">
            <a:off x="3789397" y="2094174"/>
            <a:ext cx="64119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 rot="16200000">
            <a:off x="3542954" y="1980694"/>
            <a:ext cx="811605" cy="2831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P: Flag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직선 연결선 54"/>
          <p:cNvCxnSpPr/>
          <p:nvPr/>
        </p:nvCxnSpPr>
        <p:spPr>
          <a:xfrm flipV="1">
            <a:off x="4112714" y="2526901"/>
            <a:ext cx="0" cy="96867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 rot="16200000">
            <a:off x="3438164" y="2870195"/>
            <a:ext cx="1026351" cy="2831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5378484" y="2083027"/>
            <a:ext cx="10501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B : 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5378484" y="2552766"/>
            <a:ext cx="8992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B : Flag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5378484" y="2876423"/>
            <a:ext cx="10697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B : 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5378484" y="3209219"/>
            <a:ext cx="1078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B : 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3934752" y="2153577"/>
            <a:ext cx="8277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2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3936328" y="1755068"/>
            <a:ext cx="8277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2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3934774" y="2500276"/>
            <a:ext cx="8277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20kDa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3936398" y="2885506"/>
            <a:ext cx="8277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2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3936074" y="3341957"/>
            <a:ext cx="8277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35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6" name="그림 65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67" t="79511" r="28839" b="16064"/>
          <a:stretch/>
        </p:blipFill>
        <p:spPr>
          <a:xfrm>
            <a:off x="351486" y="7723635"/>
            <a:ext cx="3132317" cy="37194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7" name="그림 66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46" t="69767" r="19766" b="19777"/>
          <a:stretch/>
        </p:blipFill>
        <p:spPr>
          <a:xfrm>
            <a:off x="238646" y="4372482"/>
            <a:ext cx="3217761" cy="69448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8" name="그림 67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10" t="82210" r="25349" b="11228"/>
          <a:stretch/>
        </p:blipFill>
        <p:spPr>
          <a:xfrm>
            <a:off x="-8000" y="5380442"/>
            <a:ext cx="3711051" cy="46223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0" name="직사각형 69"/>
          <p:cNvSpPr/>
          <p:nvPr/>
        </p:nvSpPr>
        <p:spPr>
          <a:xfrm>
            <a:off x="1872384" y="4341419"/>
            <a:ext cx="1483250" cy="5377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1" name="직사각형 70"/>
          <p:cNvSpPr/>
          <p:nvPr/>
        </p:nvSpPr>
        <p:spPr>
          <a:xfrm>
            <a:off x="1982468" y="5360779"/>
            <a:ext cx="1483250" cy="5377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2" name="직사각형 71"/>
          <p:cNvSpPr/>
          <p:nvPr/>
        </p:nvSpPr>
        <p:spPr>
          <a:xfrm>
            <a:off x="2047336" y="7678624"/>
            <a:ext cx="1483250" cy="5377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73" name="그림 72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853" t="59083" r="11869" b="32878"/>
          <a:stretch/>
        </p:blipFill>
        <p:spPr>
          <a:xfrm>
            <a:off x="4527649" y="7909610"/>
            <a:ext cx="1006997" cy="7292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4" name="그림 73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7" t="72629" r="71178" b="15398"/>
          <a:stretch/>
        </p:blipFill>
        <p:spPr>
          <a:xfrm>
            <a:off x="4201611" y="4213185"/>
            <a:ext cx="1250066" cy="104172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5" name="그림 74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675" t="70120" r="49783" b="18378"/>
          <a:stretch/>
        </p:blipFill>
        <p:spPr>
          <a:xfrm>
            <a:off x="4348614" y="6028822"/>
            <a:ext cx="1134318" cy="10185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6" name="그림 75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448" t="72926" r="33767" b="15721"/>
          <a:stretch/>
        </p:blipFill>
        <p:spPr>
          <a:xfrm>
            <a:off x="4296142" y="5342104"/>
            <a:ext cx="1032154" cy="64706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7" name="그림 76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532" t="75610" r="10701" b="14860"/>
          <a:stretch/>
        </p:blipFill>
        <p:spPr>
          <a:xfrm>
            <a:off x="4416830" y="7142836"/>
            <a:ext cx="1030146" cy="67133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8" name="직사각형 77"/>
          <p:cNvSpPr/>
          <p:nvPr/>
        </p:nvSpPr>
        <p:spPr>
          <a:xfrm>
            <a:off x="4433534" y="4404229"/>
            <a:ext cx="856448" cy="3201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9" name="직사각형 78"/>
          <p:cNvSpPr/>
          <p:nvPr/>
        </p:nvSpPr>
        <p:spPr>
          <a:xfrm>
            <a:off x="4471848" y="5675604"/>
            <a:ext cx="856448" cy="3201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0" name="직사각형 79"/>
          <p:cNvSpPr/>
          <p:nvPr/>
        </p:nvSpPr>
        <p:spPr>
          <a:xfrm>
            <a:off x="4487549" y="6442146"/>
            <a:ext cx="856448" cy="3201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1" name="직사각형 80"/>
          <p:cNvSpPr/>
          <p:nvPr/>
        </p:nvSpPr>
        <p:spPr>
          <a:xfrm>
            <a:off x="4473550" y="7290932"/>
            <a:ext cx="856448" cy="3201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2" name="직사각형 81"/>
          <p:cNvSpPr/>
          <p:nvPr/>
        </p:nvSpPr>
        <p:spPr>
          <a:xfrm>
            <a:off x="4626484" y="8114126"/>
            <a:ext cx="856448" cy="3201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83" name="그림 82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45" t="70349" r="26328" b="10943"/>
          <a:stretch/>
        </p:blipFill>
        <p:spPr>
          <a:xfrm rot="21413017">
            <a:off x="151135" y="6075628"/>
            <a:ext cx="3508220" cy="13688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4" name="직사각형 83"/>
          <p:cNvSpPr/>
          <p:nvPr/>
        </p:nvSpPr>
        <p:spPr>
          <a:xfrm>
            <a:off x="1914997" y="6333367"/>
            <a:ext cx="1483250" cy="5377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4719037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179079"/>
            <a:ext cx="21739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3EDAFE4-A364-4634-B29E-989391D86E25}"/>
              </a:ext>
            </a:extLst>
          </p:cNvPr>
          <p:cNvSpPr txBox="1"/>
          <p:nvPr/>
        </p:nvSpPr>
        <p:spPr>
          <a:xfrm>
            <a:off x="783327" y="1328333"/>
            <a:ext cx="5949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siCT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9BAFE4B-68AC-4662-811B-61CC1F7FCE7C}"/>
              </a:ext>
            </a:extLst>
          </p:cNvPr>
          <p:cNvSpPr txBox="1"/>
          <p:nvPr/>
        </p:nvSpPr>
        <p:spPr>
          <a:xfrm>
            <a:off x="578747" y="1536193"/>
            <a:ext cx="7995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i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FAD1F01-F902-4F63-8AE6-B6B0CEEA75F4}"/>
              </a:ext>
            </a:extLst>
          </p:cNvPr>
          <p:cNvSpPr txBox="1"/>
          <p:nvPr/>
        </p:nvSpPr>
        <p:spPr>
          <a:xfrm>
            <a:off x="1371531" y="1521695"/>
            <a:ext cx="2532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0D1B330-FD20-4F29-ABB0-FD714E0456B1}"/>
              </a:ext>
            </a:extLst>
          </p:cNvPr>
          <p:cNvSpPr txBox="1"/>
          <p:nvPr/>
        </p:nvSpPr>
        <p:spPr>
          <a:xfrm>
            <a:off x="1709691" y="1325568"/>
            <a:ext cx="2532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8EE111E-D701-4714-BCD6-4692E702224C}"/>
              </a:ext>
            </a:extLst>
          </p:cNvPr>
          <p:cNvSpPr txBox="1"/>
          <p:nvPr/>
        </p:nvSpPr>
        <p:spPr>
          <a:xfrm>
            <a:off x="1706341" y="1521695"/>
            <a:ext cx="2532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CC20E9C-4470-4A00-B4B8-139274B422A3}"/>
              </a:ext>
            </a:extLst>
          </p:cNvPr>
          <p:cNvSpPr txBox="1"/>
          <p:nvPr/>
        </p:nvSpPr>
        <p:spPr>
          <a:xfrm>
            <a:off x="1371531" y="1325568"/>
            <a:ext cx="2532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1359679-B571-43FB-81A2-2F86477218F7}"/>
              </a:ext>
            </a:extLst>
          </p:cNvPr>
          <p:cNvSpPr txBox="1"/>
          <p:nvPr/>
        </p:nvSpPr>
        <p:spPr>
          <a:xfrm>
            <a:off x="1935437" y="1801042"/>
            <a:ext cx="5940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nai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694B636-80A0-40D1-A9B5-2A040EB20067}"/>
              </a:ext>
            </a:extLst>
          </p:cNvPr>
          <p:cNvSpPr txBox="1"/>
          <p:nvPr/>
        </p:nvSpPr>
        <p:spPr>
          <a:xfrm>
            <a:off x="1935437" y="2122961"/>
            <a:ext cx="8606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E-cadher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F223E5D-2658-42EE-8116-C956AAC7C692}"/>
              </a:ext>
            </a:extLst>
          </p:cNvPr>
          <p:cNvSpPr txBox="1"/>
          <p:nvPr/>
        </p:nvSpPr>
        <p:spPr>
          <a:xfrm>
            <a:off x="1936267" y="2772351"/>
            <a:ext cx="6340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그림 12">
            <a:extLst>
              <a:ext uri="{FF2B5EF4-FFF2-40B4-BE49-F238E27FC236}">
                <a16:creationId xmlns:a16="http://schemas.microsoft.com/office/drawing/2014/main" id="{B100317D-CD63-48C2-ABF2-4DCFC5C05F1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15" t="10767" r="73067" b="85580"/>
          <a:stretch/>
        </p:blipFill>
        <p:spPr>
          <a:xfrm>
            <a:off x="1330855" y="2088958"/>
            <a:ext cx="64800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2058FFA6-CBCF-487F-B4FD-F9E49524281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67" t="33800" r="71516" b="63568"/>
          <a:stretch/>
        </p:blipFill>
        <p:spPr>
          <a:xfrm>
            <a:off x="1330855" y="2744633"/>
            <a:ext cx="64800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C13099FD-CE1D-4500-94D8-453E386965E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10000" contrast="7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958" t="48332" r="72282" b="49236"/>
          <a:stretch/>
        </p:blipFill>
        <p:spPr>
          <a:xfrm>
            <a:off x="1330855" y="1761120"/>
            <a:ext cx="64800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EE7E62B9-6E5A-4715-9A3D-272F3093D489}"/>
              </a:ext>
            </a:extLst>
          </p:cNvPr>
          <p:cNvSpPr txBox="1"/>
          <p:nvPr/>
        </p:nvSpPr>
        <p:spPr>
          <a:xfrm>
            <a:off x="1936267" y="2452642"/>
            <a:ext cx="6340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UBE2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그림 16">
            <a:extLst>
              <a:ext uri="{FF2B5EF4-FFF2-40B4-BE49-F238E27FC236}">
                <a16:creationId xmlns:a16="http://schemas.microsoft.com/office/drawing/2014/main" id="{779F0CB3-2927-46A3-AB39-0CDDD10D762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673" t="63010" r="55294" b="32714"/>
          <a:stretch/>
        </p:blipFill>
        <p:spPr>
          <a:xfrm>
            <a:off x="1330855" y="2416796"/>
            <a:ext cx="64800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E23C2F40-2B0C-4529-8C36-43D584CB6EAA}"/>
              </a:ext>
            </a:extLst>
          </p:cNvPr>
          <p:cNvSpPr txBox="1"/>
          <p:nvPr/>
        </p:nvSpPr>
        <p:spPr>
          <a:xfrm>
            <a:off x="686921" y="2441906"/>
            <a:ext cx="73009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3F1B252-48BA-49DC-9039-D38B15A8C84F}"/>
              </a:ext>
            </a:extLst>
          </p:cNvPr>
          <p:cNvSpPr txBox="1"/>
          <p:nvPr/>
        </p:nvSpPr>
        <p:spPr>
          <a:xfrm>
            <a:off x="691214" y="2888633"/>
            <a:ext cx="73009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69ABC63-C718-4DCF-98B8-436BC87A90FA}"/>
              </a:ext>
            </a:extLst>
          </p:cNvPr>
          <p:cNvSpPr txBox="1"/>
          <p:nvPr/>
        </p:nvSpPr>
        <p:spPr>
          <a:xfrm>
            <a:off x="691214" y="1925841"/>
            <a:ext cx="73009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67117C6-4CD1-4DE2-BC28-1CBA1A11F2EF}"/>
              </a:ext>
            </a:extLst>
          </p:cNvPr>
          <p:cNvSpPr txBox="1"/>
          <p:nvPr/>
        </p:nvSpPr>
        <p:spPr>
          <a:xfrm>
            <a:off x="367767" y="948139"/>
            <a:ext cx="3379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9E132D0-22A6-43EA-A30F-515571AE657E}"/>
              </a:ext>
            </a:extLst>
          </p:cNvPr>
          <p:cNvSpPr txBox="1"/>
          <p:nvPr/>
        </p:nvSpPr>
        <p:spPr>
          <a:xfrm>
            <a:off x="643990" y="2265547"/>
            <a:ext cx="76850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그림 22">
            <a:extLst>
              <a:ext uri="{FF2B5EF4-FFF2-40B4-BE49-F238E27FC236}">
                <a16:creationId xmlns:a16="http://schemas.microsoft.com/office/drawing/2014/main" id="{B100317D-CD63-48C2-ABF2-4DCFC5C05F1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1" t="4630" r="56691" b="80937"/>
          <a:stretch/>
        </p:blipFill>
        <p:spPr>
          <a:xfrm>
            <a:off x="193040" y="4055378"/>
            <a:ext cx="2001519" cy="11379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그림 23">
            <a:extLst>
              <a:ext uri="{FF2B5EF4-FFF2-40B4-BE49-F238E27FC236}">
                <a16:creationId xmlns:a16="http://schemas.microsoft.com/office/drawing/2014/main" id="{2058FFA6-CBCF-487F-B4FD-F9E49524281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23" t="32724" r="59421" b="61798"/>
          <a:stretch/>
        </p:blipFill>
        <p:spPr>
          <a:xfrm>
            <a:off x="337811" y="6180004"/>
            <a:ext cx="1432560" cy="5994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그림 24">
            <a:extLst>
              <a:ext uri="{FF2B5EF4-FFF2-40B4-BE49-F238E27FC236}">
                <a16:creationId xmlns:a16="http://schemas.microsoft.com/office/drawing/2014/main" id="{C13099FD-CE1D-4500-94D8-453E386965E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10000" contrast="7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604" t="47202" r="58815" b="47479"/>
          <a:stretch/>
        </p:blipFill>
        <p:spPr>
          <a:xfrm>
            <a:off x="121920" y="3362960"/>
            <a:ext cx="1574800" cy="6299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그림 25">
            <a:extLst>
              <a:ext uri="{FF2B5EF4-FFF2-40B4-BE49-F238E27FC236}">
                <a16:creationId xmlns:a16="http://schemas.microsoft.com/office/drawing/2014/main" id="{779F0CB3-2927-46A3-AB39-0CDDD10D762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674" t="63011" r="39002" b="29496"/>
          <a:stretch/>
        </p:blipFill>
        <p:spPr>
          <a:xfrm>
            <a:off x="397901" y="5483885"/>
            <a:ext cx="1458010" cy="50472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" name="직사각형 26"/>
          <p:cNvSpPr/>
          <p:nvPr/>
        </p:nvSpPr>
        <p:spPr>
          <a:xfrm>
            <a:off x="321450" y="3378516"/>
            <a:ext cx="684390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8" name="직사각형 27"/>
          <p:cNvSpPr/>
          <p:nvPr/>
        </p:nvSpPr>
        <p:spPr>
          <a:xfrm>
            <a:off x="721517" y="4315171"/>
            <a:ext cx="684390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9" name="직사각형 28"/>
          <p:cNvSpPr/>
          <p:nvPr/>
        </p:nvSpPr>
        <p:spPr>
          <a:xfrm>
            <a:off x="361434" y="5367736"/>
            <a:ext cx="684390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0" name="직사각형 29"/>
          <p:cNvSpPr/>
          <p:nvPr/>
        </p:nvSpPr>
        <p:spPr>
          <a:xfrm>
            <a:off x="461971" y="6223160"/>
            <a:ext cx="684390" cy="5092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750377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8</TotalTime>
  <Words>619</Words>
  <Application>Microsoft Office PowerPoint</Application>
  <PresentationFormat>A4 용지(210x297mm)</PresentationFormat>
  <Paragraphs>405</Paragraphs>
  <Slides>10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0</vt:i4>
      </vt:variant>
    </vt:vector>
  </HeadingPairs>
  <TitlesOfParts>
    <vt:vector size="16" baseType="lpstr">
      <vt:lpstr>맑은 고딕</vt:lpstr>
      <vt:lpstr>Arial</vt:lpstr>
      <vt:lpstr>Calibri</vt:lpstr>
      <vt:lpstr>Calibri Light</vt:lpstr>
      <vt:lpstr>Wingdings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821024284752</dc:creator>
  <cp:lastModifiedBy>Windows User</cp:lastModifiedBy>
  <cp:revision>14</cp:revision>
  <dcterms:created xsi:type="dcterms:W3CDTF">2021-02-14T13:59:02Z</dcterms:created>
  <dcterms:modified xsi:type="dcterms:W3CDTF">2021-08-18T13:33:00Z</dcterms:modified>
</cp:coreProperties>
</file>